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70" r:id="rId3"/>
    <p:sldId id="271" r:id="rId4"/>
    <p:sldId id="272" r:id="rId5"/>
    <p:sldId id="269" r:id="rId6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6D6FF"/>
    <a:srgbClr val="0096FF"/>
    <a:srgbClr val="FF2525"/>
    <a:srgbClr val="00A84C"/>
    <a:srgbClr val="FF5353"/>
    <a:srgbClr val="008A3E"/>
    <a:srgbClr val="FF3F3F"/>
    <a:srgbClr val="006400"/>
    <a:srgbClr val="00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644" autoAdjust="0"/>
    <p:restoredTop sz="94660"/>
  </p:normalViewPr>
  <p:slideViewPr>
    <p:cSldViewPr>
      <p:cViewPr varScale="1">
        <p:scale>
          <a:sx n="77" d="100"/>
          <a:sy n="77" d="100"/>
        </p:scale>
        <p:origin x="3248" y="19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576B42-F12F-49B7-ADEE-3684C522268D}" type="datetimeFigureOut">
              <a:rPr lang="fr-FR" smtClean="0"/>
              <a:t>28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880E7-AEEC-4668-9D4A-24FE574C888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0155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576B42-F12F-49B7-ADEE-3684C522268D}" type="datetimeFigureOut">
              <a:rPr lang="fr-FR" smtClean="0"/>
              <a:t>28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880E7-AEEC-4668-9D4A-24FE574C888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7160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576B42-F12F-49B7-ADEE-3684C522268D}" type="datetimeFigureOut">
              <a:rPr lang="fr-FR" smtClean="0"/>
              <a:t>28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880E7-AEEC-4668-9D4A-24FE574C888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57620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576B42-F12F-49B7-ADEE-3684C522268D}" type="datetimeFigureOut">
              <a:rPr lang="fr-FR" smtClean="0"/>
              <a:t>28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880E7-AEEC-4668-9D4A-24FE574C888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166743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576B42-F12F-49B7-ADEE-3684C522268D}" type="datetimeFigureOut">
              <a:rPr lang="fr-FR" smtClean="0"/>
              <a:t>28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880E7-AEEC-4668-9D4A-24FE574C888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50320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576B42-F12F-49B7-ADEE-3684C522268D}" type="datetimeFigureOut">
              <a:rPr lang="fr-FR" smtClean="0"/>
              <a:t>28/04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880E7-AEEC-4668-9D4A-24FE574C888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879043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576B42-F12F-49B7-ADEE-3684C522268D}" type="datetimeFigureOut">
              <a:rPr lang="fr-FR" smtClean="0"/>
              <a:t>28/04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880E7-AEEC-4668-9D4A-24FE574C888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83551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576B42-F12F-49B7-ADEE-3684C522268D}" type="datetimeFigureOut">
              <a:rPr lang="fr-FR" smtClean="0"/>
              <a:t>28/04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880E7-AEEC-4668-9D4A-24FE574C888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8766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576B42-F12F-49B7-ADEE-3684C522268D}" type="datetimeFigureOut">
              <a:rPr lang="fr-FR" smtClean="0"/>
              <a:t>28/04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880E7-AEEC-4668-9D4A-24FE574C888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25750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576B42-F12F-49B7-ADEE-3684C522268D}" type="datetimeFigureOut">
              <a:rPr lang="fr-FR" smtClean="0"/>
              <a:t>28/04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880E7-AEEC-4668-9D4A-24FE574C888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01286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576B42-F12F-49B7-ADEE-3684C522268D}" type="datetimeFigureOut">
              <a:rPr lang="fr-FR" smtClean="0"/>
              <a:t>28/04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880E7-AEEC-4668-9D4A-24FE574C888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559678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576B42-F12F-49B7-ADEE-3684C522268D}" type="datetimeFigureOut">
              <a:rPr lang="fr-FR" smtClean="0"/>
              <a:t>28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3880E7-AEEC-4668-9D4A-24FE574C888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74143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tiff"/><Relationship Id="rId3" Type="http://schemas.openxmlformats.org/officeDocument/2006/relationships/image" Target="../media/image7.tiff"/><Relationship Id="rId7" Type="http://schemas.openxmlformats.org/officeDocument/2006/relationships/image" Target="../media/image11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tiff"/><Relationship Id="rId5" Type="http://schemas.openxmlformats.org/officeDocument/2006/relationships/image" Target="../media/image9.tiff"/><Relationship Id="rId4" Type="http://schemas.openxmlformats.org/officeDocument/2006/relationships/image" Target="../media/image8.tiff"/><Relationship Id="rId9" Type="http://schemas.openxmlformats.org/officeDocument/2006/relationships/image" Target="../media/image13.tif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f"/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er 5"/>
          <p:cNvGrpSpPr/>
          <p:nvPr/>
        </p:nvGrpSpPr>
        <p:grpSpPr>
          <a:xfrm>
            <a:off x="873944" y="56456"/>
            <a:ext cx="5110112" cy="4070203"/>
            <a:chOff x="820146" y="194148"/>
            <a:chExt cx="5110112" cy="4070203"/>
          </a:xfrm>
        </p:grpSpPr>
        <p:pic>
          <p:nvPicPr>
            <p:cNvPr id="7" name="Picture 3"/>
            <p:cNvPicPr>
              <a:picLocks noChangeAspect="1" noChangeArrowheads="1"/>
            </p:cNvPicPr>
            <p:nvPr/>
          </p:nvPicPr>
          <p:blipFill>
            <a:blip r:embed="rId2" cstate="print"/>
            <a:srcRect t="7950" b="11926"/>
            <a:stretch>
              <a:fillRect/>
            </a:stretch>
          </p:blipFill>
          <p:spPr bwMode="auto">
            <a:xfrm>
              <a:off x="820146" y="488504"/>
              <a:ext cx="891696" cy="6770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56" name="Picture 34"/>
            <p:cNvPicPr preferRelativeResize="0">
              <a:picLocks noChangeArrowheads="1"/>
            </p:cNvPicPr>
            <p:nvPr/>
          </p:nvPicPr>
          <p:blipFill rotWithShape="1">
            <a:blip r:embed="rId3">
              <a:lum bright="6000" contrast="6000"/>
            </a:blip>
            <a:srcRect r="2393"/>
            <a:stretch/>
          </p:blipFill>
          <p:spPr bwMode="auto">
            <a:xfrm>
              <a:off x="1124796" y="3057201"/>
              <a:ext cx="936000" cy="863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51" name="Picture 39"/>
            <p:cNvPicPr>
              <a:picLocks noChangeAspect="1" noChangeArrowheads="1"/>
            </p:cNvPicPr>
            <p:nvPr/>
          </p:nvPicPr>
          <p:blipFill rotWithShape="1">
            <a:blip r:embed="rId4">
              <a:lum bright="-6000" contrast="12000"/>
            </a:blip>
            <a:srcRect r="2393"/>
            <a:stretch/>
          </p:blipFill>
          <p:spPr bwMode="auto">
            <a:xfrm>
              <a:off x="2251004" y="3057152"/>
              <a:ext cx="936000" cy="8640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11" name="Groupe 83"/>
            <p:cNvGrpSpPr>
              <a:grpSpLocks/>
            </p:cNvGrpSpPr>
            <p:nvPr/>
          </p:nvGrpSpPr>
          <p:grpSpPr bwMode="auto">
            <a:xfrm>
              <a:off x="1719117" y="978781"/>
              <a:ext cx="928873" cy="354778"/>
              <a:chOff x="1780420" y="3363284"/>
              <a:chExt cx="1277992" cy="1306094"/>
            </a:xfrm>
          </p:grpSpPr>
          <p:sp>
            <p:nvSpPr>
              <p:cNvPr id="49" name="Text Box 10"/>
              <p:cNvSpPr txBox="1">
                <a:spLocks noChangeArrowheads="1"/>
              </p:cNvSpPr>
              <p:nvPr/>
            </p:nvSpPr>
            <p:spPr bwMode="auto">
              <a:xfrm>
                <a:off x="1780420" y="3762930"/>
                <a:ext cx="1277992" cy="9064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fr-FR" sz="1000" dirty="0">
                    <a:latin typeface="Times New Roman" pitchFamily="18" charset="0"/>
                    <a:cs typeface="Times New Roman" pitchFamily="18" charset="0"/>
                  </a:rPr>
                  <a:t>Insert </a:t>
                </a:r>
                <a:r>
                  <a:rPr lang="fr-FR" sz="1000" dirty="0" err="1">
                    <a:latin typeface="Times New Roman" pitchFamily="18" charset="0"/>
                    <a:cs typeface="Times New Roman" pitchFamily="18" charset="0"/>
                  </a:rPr>
                  <a:t>removal</a:t>
                </a:r>
                <a:endParaRPr lang="fr-FR" sz="1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0" name="Line 17"/>
              <p:cNvSpPr>
                <a:spLocks noChangeShapeType="1"/>
              </p:cNvSpPr>
              <p:nvPr/>
            </p:nvSpPr>
            <p:spPr bwMode="auto">
              <a:xfrm>
                <a:off x="2446689" y="3363284"/>
                <a:ext cx="2824" cy="608285"/>
              </a:xfrm>
              <a:prstGeom prst="line">
                <a:avLst/>
              </a:prstGeom>
              <a:ln>
                <a:headEnd/>
                <a:tailEnd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  <p:txBody>
              <a:bodyPr/>
              <a:lstStyle/>
              <a:p>
                <a:pPr algn="ctr"/>
                <a:endParaRPr lang="fr-FR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12" name="Groupe 11"/>
            <p:cNvGrpSpPr/>
            <p:nvPr/>
          </p:nvGrpSpPr>
          <p:grpSpPr>
            <a:xfrm>
              <a:off x="1741602" y="723166"/>
              <a:ext cx="3799510" cy="207695"/>
              <a:chOff x="363764" y="6296257"/>
              <a:chExt cx="6112704" cy="360367"/>
            </a:xfrm>
          </p:grpSpPr>
          <p:sp>
            <p:nvSpPr>
              <p:cNvPr id="39" name="AutoShape 7"/>
              <p:cNvSpPr>
                <a:spLocks noChangeArrowheads="1"/>
              </p:cNvSpPr>
              <p:nvPr/>
            </p:nvSpPr>
            <p:spPr bwMode="auto">
              <a:xfrm>
                <a:off x="363764" y="6296257"/>
                <a:ext cx="934946" cy="360362"/>
              </a:xfrm>
              <a:prstGeom prst="chevron">
                <a:avLst>
                  <a:gd name="adj" fmla="val 64868"/>
                </a:avLst>
              </a:prstGeom>
              <a:ln>
                <a:headEnd/>
                <a:tailEnd/>
              </a:ln>
            </p:spPr>
            <p:style>
              <a:lnRef idx="0">
                <a:schemeClr val="dk1"/>
              </a:lnRef>
              <a:fillRef idx="3">
                <a:schemeClr val="dk1"/>
              </a:fillRef>
              <a:effectRef idx="3">
                <a:schemeClr val="dk1"/>
              </a:effectRef>
              <a:fontRef idx="minor">
                <a:schemeClr val="lt1"/>
              </a:fontRef>
            </p:style>
            <p:txBody>
              <a:bodyPr wrap="none" anchor="ctr"/>
              <a:lstStyle/>
              <a:p>
                <a:pPr algn="ctr"/>
                <a:r>
                  <a:rPr lang="fr-FR" sz="1000" b="1" dirty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D0</a:t>
                </a:r>
              </a:p>
            </p:txBody>
          </p:sp>
          <p:grpSp>
            <p:nvGrpSpPr>
              <p:cNvPr id="40" name="Groupe 39"/>
              <p:cNvGrpSpPr/>
              <p:nvPr/>
            </p:nvGrpSpPr>
            <p:grpSpPr>
              <a:xfrm>
                <a:off x="1128238" y="6296260"/>
                <a:ext cx="5348230" cy="360364"/>
                <a:chOff x="1128238" y="6296260"/>
                <a:chExt cx="5348230" cy="360364"/>
              </a:xfrm>
              <a:solidFill>
                <a:schemeClr val="tx1">
                  <a:lumMod val="65000"/>
                  <a:lumOff val="35000"/>
                </a:schemeClr>
              </a:solidFill>
            </p:grpSpPr>
            <p:sp>
              <p:nvSpPr>
                <p:cNvPr id="41" name="AutoShape 14"/>
                <p:cNvSpPr>
                  <a:spLocks noChangeArrowheads="1"/>
                </p:cNvSpPr>
                <p:nvPr/>
              </p:nvSpPr>
              <p:spPr bwMode="auto">
                <a:xfrm>
                  <a:off x="3402932" y="6296260"/>
                  <a:ext cx="935038" cy="360362"/>
                </a:xfrm>
                <a:prstGeom prst="chevron">
                  <a:avLst>
                    <a:gd name="adj" fmla="val 64868"/>
                  </a:avLst>
                </a:prstGeom>
                <a:grpFill/>
                <a:ln>
                  <a:headEnd/>
                  <a:tailEnd/>
                </a:ln>
              </p:spPr>
              <p:style>
                <a:lnRef idx="0">
                  <a:schemeClr val="accent5"/>
                </a:lnRef>
                <a:fillRef idx="3">
                  <a:schemeClr val="accent5"/>
                </a:fillRef>
                <a:effectRef idx="3">
                  <a:schemeClr val="accent5"/>
                </a:effectRef>
                <a:fontRef idx="minor">
                  <a:schemeClr val="lt1"/>
                </a:fontRef>
              </p:style>
              <p:txBody>
                <a:bodyPr wrap="none" anchor="ctr"/>
                <a:lstStyle/>
                <a:p>
                  <a:pPr algn="ctr">
                    <a:defRPr/>
                  </a:pPr>
                  <a:r>
                    <a:rPr lang="fr-FR" sz="1000" b="1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rPr>
                    <a:t>D4</a:t>
                  </a:r>
                </a:p>
              </p:txBody>
            </p:sp>
            <p:sp>
              <p:nvSpPr>
                <p:cNvPr id="42" name="AutoShape 20"/>
                <p:cNvSpPr>
                  <a:spLocks noChangeArrowheads="1"/>
                </p:cNvSpPr>
                <p:nvPr/>
              </p:nvSpPr>
              <p:spPr bwMode="auto">
                <a:xfrm>
                  <a:off x="5541430" y="6296260"/>
                  <a:ext cx="935038" cy="360362"/>
                </a:xfrm>
                <a:prstGeom prst="chevron">
                  <a:avLst>
                    <a:gd name="adj" fmla="val 64868"/>
                  </a:avLst>
                </a:prstGeom>
                <a:grpFill/>
                <a:ln>
                  <a:headEnd/>
                  <a:tailEnd/>
                </a:ln>
              </p:spPr>
              <p:style>
                <a:lnRef idx="0">
                  <a:schemeClr val="accent5"/>
                </a:lnRef>
                <a:fillRef idx="3">
                  <a:schemeClr val="accent5"/>
                </a:fillRef>
                <a:effectRef idx="3">
                  <a:schemeClr val="accent5"/>
                </a:effectRef>
                <a:fontRef idx="minor">
                  <a:schemeClr val="lt1"/>
                </a:fontRef>
              </p:style>
              <p:txBody>
                <a:bodyPr wrap="none" anchor="ctr"/>
                <a:lstStyle/>
                <a:p>
                  <a:pPr algn="ctr">
                    <a:defRPr/>
                  </a:pPr>
                  <a:r>
                    <a:rPr lang="fr-FR" sz="1000" b="1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rPr>
                    <a:t>D33</a:t>
                  </a:r>
                </a:p>
              </p:txBody>
            </p:sp>
            <p:sp>
              <p:nvSpPr>
                <p:cNvPr id="43" name="AutoShape 22"/>
                <p:cNvSpPr>
                  <a:spLocks noChangeArrowheads="1"/>
                </p:cNvSpPr>
                <p:nvPr/>
              </p:nvSpPr>
              <p:spPr bwMode="auto">
                <a:xfrm>
                  <a:off x="4774336" y="6296260"/>
                  <a:ext cx="935038" cy="360362"/>
                </a:xfrm>
                <a:prstGeom prst="chevron">
                  <a:avLst>
                    <a:gd name="adj" fmla="val 64868"/>
                  </a:avLst>
                </a:prstGeom>
                <a:grpFill/>
                <a:ln>
                  <a:headEnd/>
                  <a:tailEnd/>
                </a:ln>
              </p:spPr>
              <p:style>
                <a:lnRef idx="0">
                  <a:schemeClr val="accent5"/>
                </a:lnRef>
                <a:fillRef idx="3">
                  <a:schemeClr val="accent5"/>
                </a:fillRef>
                <a:effectRef idx="3">
                  <a:schemeClr val="accent5"/>
                </a:effectRef>
                <a:fontRef idx="minor">
                  <a:schemeClr val="lt1"/>
                </a:fontRef>
              </p:style>
              <p:txBody>
                <a:bodyPr wrap="none" anchor="ctr"/>
                <a:lstStyle/>
                <a:p>
                  <a:pPr algn="ctr">
                    <a:defRPr/>
                  </a:pPr>
                  <a:r>
                    <a:rPr lang="fr-FR" sz="1000" b="1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rPr>
                    <a:t>D32</a:t>
                  </a:r>
                </a:p>
              </p:txBody>
            </p:sp>
            <p:sp>
              <p:nvSpPr>
                <p:cNvPr id="44" name="AutoShape 24"/>
                <p:cNvSpPr>
                  <a:spLocks noChangeArrowheads="1"/>
                </p:cNvSpPr>
                <p:nvPr/>
              </p:nvSpPr>
              <p:spPr bwMode="auto">
                <a:xfrm>
                  <a:off x="4456507" y="6296260"/>
                  <a:ext cx="503239" cy="360362"/>
                </a:xfrm>
                <a:prstGeom prst="chevron">
                  <a:avLst>
                    <a:gd name="adj" fmla="val 79709"/>
                  </a:avLst>
                </a:prstGeom>
                <a:grpFill/>
                <a:ln>
                  <a:headEnd/>
                  <a:tailEnd/>
                </a:ln>
              </p:spPr>
              <p:style>
                <a:lnRef idx="0">
                  <a:schemeClr val="accent5"/>
                </a:lnRef>
                <a:fillRef idx="3">
                  <a:schemeClr val="accent5"/>
                </a:fillRef>
                <a:effectRef idx="3">
                  <a:schemeClr val="accent5"/>
                </a:effectRef>
                <a:fontRef idx="minor">
                  <a:schemeClr val="lt1"/>
                </a:fontRef>
              </p:style>
              <p:txBody>
                <a:bodyPr wrap="none" anchor="ctr"/>
                <a:lstStyle/>
                <a:p>
                  <a:pPr algn="ctr">
                    <a:defRPr/>
                  </a:pPr>
                  <a:endParaRPr lang="fr-FR" sz="1400" b="1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45" name="AutoShape 62"/>
                <p:cNvSpPr>
                  <a:spLocks noChangeArrowheads="1"/>
                </p:cNvSpPr>
                <p:nvPr/>
              </p:nvSpPr>
              <p:spPr bwMode="auto">
                <a:xfrm>
                  <a:off x="4158470" y="6296260"/>
                  <a:ext cx="503239" cy="360362"/>
                </a:xfrm>
                <a:prstGeom prst="chevron">
                  <a:avLst>
                    <a:gd name="adj" fmla="val 79709"/>
                  </a:avLst>
                </a:prstGeom>
                <a:grpFill/>
                <a:ln>
                  <a:headEnd/>
                  <a:tailEnd/>
                </a:ln>
              </p:spPr>
              <p:style>
                <a:lnRef idx="0">
                  <a:schemeClr val="accent5"/>
                </a:lnRef>
                <a:fillRef idx="3">
                  <a:schemeClr val="accent5"/>
                </a:fillRef>
                <a:effectRef idx="3">
                  <a:schemeClr val="accent5"/>
                </a:effectRef>
                <a:fontRef idx="minor">
                  <a:schemeClr val="lt1"/>
                </a:fontRef>
              </p:style>
              <p:txBody>
                <a:bodyPr wrap="none" anchor="ctr"/>
                <a:lstStyle/>
                <a:p>
                  <a:pPr algn="ctr">
                    <a:defRPr/>
                  </a:pPr>
                  <a:endParaRPr lang="fr-FR" sz="1400" b="1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46" name="AutoShape 14"/>
                <p:cNvSpPr>
                  <a:spLocks noChangeArrowheads="1"/>
                </p:cNvSpPr>
                <p:nvPr/>
              </p:nvSpPr>
              <p:spPr bwMode="auto">
                <a:xfrm>
                  <a:off x="2646950" y="6296260"/>
                  <a:ext cx="933450" cy="360364"/>
                </a:xfrm>
                <a:prstGeom prst="chevron">
                  <a:avLst>
                    <a:gd name="adj" fmla="val 64868"/>
                  </a:avLst>
                </a:prstGeom>
                <a:grpFill/>
                <a:ln>
                  <a:headEnd/>
                  <a:tailEnd/>
                </a:ln>
              </p:spPr>
              <p:style>
                <a:lnRef idx="0">
                  <a:schemeClr val="accent5"/>
                </a:lnRef>
                <a:fillRef idx="3">
                  <a:schemeClr val="accent5"/>
                </a:fillRef>
                <a:effectRef idx="3">
                  <a:schemeClr val="accent5"/>
                </a:effectRef>
                <a:fontRef idx="minor">
                  <a:schemeClr val="lt1"/>
                </a:fontRef>
              </p:style>
              <p:txBody>
                <a:bodyPr wrap="none" anchor="ctr"/>
                <a:lstStyle/>
                <a:p>
                  <a:pPr algn="ctr">
                    <a:defRPr/>
                  </a:pPr>
                  <a:r>
                    <a:rPr lang="fr-FR" sz="1000" b="1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rPr>
                    <a:t>D3</a:t>
                  </a:r>
                </a:p>
              </p:txBody>
            </p:sp>
            <p:sp>
              <p:nvSpPr>
                <p:cNvPr id="47" name="AutoShape 11"/>
                <p:cNvSpPr>
                  <a:spLocks noChangeArrowheads="1"/>
                </p:cNvSpPr>
                <p:nvPr/>
              </p:nvSpPr>
              <p:spPr bwMode="auto">
                <a:xfrm>
                  <a:off x="1128238" y="6296262"/>
                  <a:ext cx="934159" cy="360360"/>
                </a:xfrm>
                <a:prstGeom prst="chevron">
                  <a:avLst>
                    <a:gd name="adj" fmla="val 64868"/>
                  </a:avLst>
                </a:prstGeom>
                <a:grpFill/>
                <a:ln>
                  <a:headEnd/>
                  <a:tailEnd/>
                </a:ln>
              </p:spPr>
              <p:style>
                <a:lnRef idx="0">
                  <a:schemeClr val="accent1"/>
                </a:lnRef>
                <a:fillRef idx="3">
                  <a:schemeClr val="accent1"/>
                </a:fillRef>
                <a:effectRef idx="3">
                  <a:schemeClr val="accent1"/>
                </a:effectRef>
                <a:fontRef idx="minor">
                  <a:schemeClr val="lt1"/>
                </a:fontRef>
              </p:style>
              <p:txBody>
                <a:bodyPr wrap="none" anchor="ctr"/>
                <a:lstStyle/>
                <a:p>
                  <a:pPr algn="ctr"/>
                  <a:r>
                    <a:rPr lang="fr-FR" sz="1000" b="1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rPr>
                    <a:t>D1</a:t>
                  </a:r>
                </a:p>
              </p:txBody>
            </p:sp>
            <p:sp>
              <p:nvSpPr>
                <p:cNvPr id="48" name="AutoShape 12"/>
                <p:cNvSpPr>
                  <a:spLocks noChangeArrowheads="1"/>
                </p:cNvSpPr>
                <p:nvPr/>
              </p:nvSpPr>
              <p:spPr bwMode="auto">
                <a:xfrm>
                  <a:off x="1886171" y="6296262"/>
                  <a:ext cx="934159" cy="360360"/>
                </a:xfrm>
                <a:prstGeom prst="chevron">
                  <a:avLst>
                    <a:gd name="adj" fmla="val 64868"/>
                  </a:avLst>
                </a:prstGeom>
                <a:grpFill/>
                <a:ln>
                  <a:headEnd/>
                  <a:tailEnd/>
                </a:ln>
              </p:spPr>
              <p:style>
                <a:lnRef idx="0">
                  <a:schemeClr val="accent1"/>
                </a:lnRef>
                <a:fillRef idx="3">
                  <a:schemeClr val="accent1"/>
                </a:fillRef>
                <a:effectRef idx="3">
                  <a:schemeClr val="accent1"/>
                </a:effectRef>
                <a:fontRef idx="minor">
                  <a:schemeClr val="lt1"/>
                </a:fontRef>
              </p:style>
              <p:txBody>
                <a:bodyPr wrap="none" anchor="ctr"/>
                <a:lstStyle/>
                <a:p>
                  <a:pPr algn="ctr"/>
                  <a:r>
                    <a:rPr lang="fr-FR" sz="1000" b="1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rPr>
                    <a:t>D2</a:t>
                  </a:r>
                </a:p>
              </p:txBody>
            </p:sp>
          </p:grpSp>
        </p:grpSp>
        <p:grpSp>
          <p:nvGrpSpPr>
            <p:cNvPr id="13" name="Groupe 12"/>
            <p:cNvGrpSpPr/>
            <p:nvPr/>
          </p:nvGrpSpPr>
          <p:grpSpPr>
            <a:xfrm>
              <a:off x="1723501" y="1232481"/>
              <a:ext cx="920104" cy="898808"/>
              <a:chOff x="1578026" y="6150413"/>
              <a:chExt cx="1477984" cy="1366827"/>
            </a:xfrm>
          </p:grpSpPr>
          <p:sp>
            <p:nvSpPr>
              <p:cNvPr id="35" name="Oval 40" descr="Pointillés"/>
              <p:cNvSpPr>
                <a:spLocks noChangeArrowheads="1"/>
              </p:cNvSpPr>
              <p:nvPr/>
            </p:nvSpPr>
            <p:spPr bwMode="auto">
              <a:xfrm rot="1579588">
                <a:off x="1578026" y="6150413"/>
                <a:ext cx="1477984" cy="1366827"/>
              </a:xfrm>
              <a:prstGeom prst="ellipse">
                <a:avLst/>
              </a:prstGeom>
              <a:pattFill prst="smConfetti">
                <a:fgClr>
                  <a:schemeClr val="bg1"/>
                </a:fgClr>
                <a:bgClr>
                  <a:srgbClr val="FF5353"/>
                </a:bgClr>
              </a:pattFill>
              <a:ln w="9525">
                <a:solidFill>
                  <a:schemeClr val="bg1"/>
                </a:solidFill>
                <a:round/>
                <a:headEnd/>
                <a:tailEnd/>
              </a:ln>
              <a:effectLst>
                <a:outerShdw blurRad="127000" dist="38100" dir="2700000" algn="ctr">
                  <a:srgbClr val="000000">
                    <a:alpha val="45000"/>
                  </a:srgbClr>
                </a:outerShdw>
              </a:effectLst>
              <a:scene3d>
                <a:camera prst="perspectiveFront" fov="2700000">
                  <a:rot lat="20376000" lon="1938000" rev="20112001"/>
                </a:camera>
                <a:lightRig rig="threePt" dir="t">
                  <a:rot lat="0" lon="0" rev="0"/>
                </a:lightRig>
              </a:scene3d>
              <a:sp3d>
                <a:bevelT w="203200" h="50800"/>
                <a:bevelB w="152400" h="50800" prst="softRound"/>
              </a:sp3d>
            </p:spPr>
            <p:txBody>
              <a:bodyPr wrap="none" anchor="ctr"/>
              <a:lstStyle/>
              <a:p>
                <a:pPr algn="ctr"/>
                <a:endParaRPr lang="fr-FR"/>
              </a:p>
            </p:txBody>
          </p:sp>
          <p:grpSp>
            <p:nvGrpSpPr>
              <p:cNvPr id="36" name="Groupe 35"/>
              <p:cNvGrpSpPr/>
              <p:nvPr/>
            </p:nvGrpSpPr>
            <p:grpSpPr>
              <a:xfrm>
                <a:off x="1839605" y="6221964"/>
                <a:ext cx="968810" cy="896839"/>
                <a:chOff x="5734871" y="5861283"/>
                <a:chExt cx="968810" cy="896839"/>
              </a:xfrm>
            </p:grpSpPr>
            <p:sp>
              <p:nvSpPr>
                <p:cNvPr id="37" name="Oval 42" descr="Pointillés"/>
                <p:cNvSpPr>
                  <a:spLocks noChangeAspect="1" noChangeArrowheads="1"/>
                </p:cNvSpPr>
                <p:nvPr/>
              </p:nvSpPr>
              <p:spPr bwMode="auto">
                <a:xfrm rot="1560000">
                  <a:off x="5734871" y="5861283"/>
                  <a:ext cx="968810" cy="896839"/>
                </a:xfrm>
                <a:prstGeom prst="ellipse">
                  <a:avLst/>
                </a:prstGeom>
                <a:solidFill>
                  <a:schemeClr val="bg1"/>
                </a:solidFill>
                <a:ln w="19050">
                  <a:noFill/>
                  <a:round/>
                  <a:headEnd/>
                  <a:tailEnd/>
                </a:ln>
                <a:effectLst>
                  <a:outerShdw blurRad="127000" dist="38100" dir="2700000" algn="ctr">
                    <a:srgbClr val="000000">
                      <a:alpha val="45000"/>
                    </a:srgbClr>
                  </a:outerShdw>
                </a:effectLst>
                <a:scene3d>
                  <a:camera prst="perspectiveFront" fov="7200000">
                    <a:rot lat="19800000" lon="1938000" rev="20400000"/>
                  </a:camera>
                  <a:lightRig rig="threePt" dir="t">
                    <a:rot lat="0" lon="0" rev="0"/>
                  </a:lightRig>
                </a:scene3d>
                <a:sp3d>
                  <a:bevelT w="222250" h="127000" prst="slope"/>
                  <a:bevelB w="0" h="0" prst="slope"/>
                </a:sp3d>
              </p:spPr>
              <p:txBody>
                <a:bodyPr wrap="none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38" name="Oval 42" descr="Pointillés"/>
                <p:cNvSpPr>
                  <a:spLocks noChangeAspect="1" noChangeArrowheads="1"/>
                </p:cNvSpPr>
                <p:nvPr/>
              </p:nvSpPr>
              <p:spPr bwMode="auto">
                <a:xfrm rot="1591748">
                  <a:off x="6015275" y="6144897"/>
                  <a:ext cx="392062" cy="280723"/>
                </a:xfrm>
                <a:prstGeom prst="ellipse">
                  <a:avLst/>
                </a:prstGeom>
                <a:pattFill prst="smConfetti">
                  <a:fgClr>
                    <a:schemeClr val="bg1"/>
                  </a:fgClr>
                  <a:bgClr>
                    <a:srgbClr val="00A84C"/>
                  </a:bgClr>
                </a:pattFill>
                <a:ln w="19050">
                  <a:noFill/>
                  <a:round/>
                  <a:headEnd/>
                  <a:tailEnd/>
                </a:ln>
                <a:effectLst>
                  <a:outerShdw blurRad="127000" dist="38100" dir="2700000" algn="ctr">
                    <a:srgbClr val="000000">
                      <a:alpha val="45000"/>
                    </a:srgbClr>
                  </a:outerShdw>
                </a:effectLst>
                <a:scene3d>
                  <a:camera prst="isometricTopUp">
                    <a:rot lat="20226062" lon="1213498" rev="635140"/>
                  </a:camera>
                  <a:lightRig rig="threePt" dir="t">
                    <a:rot lat="0" lon="0" rev="0"/>
                  </a:lightRig>
                </a:scene3d>
                <a:sp3d>
                  <a:bevelT w="203200" h="50800" prst="coolSlant"/>
                  <a:bevelB w="152400" h="50800" prst="softRound"/>
                </a:sp3d>
              </p:spPr>
              <p:txBody>
                <a:bodyPr wrap="none" anchor="ctr"/>
                <a:lstStyle/>
                <a:p>
                  <a:pPr algn="ctr"/>
                  <a:endParaRPr lang="fr-FR"/>
                </a:p>
              </p:txBody>
            </p:sp>
          </p:grpSp>
        </p:grpSp>
        <p:sp>
          <p:nvSpPr>
            <p:cNvPr id="14" name="ZoneTexte 13"/>
            <p:cNvSpPr txBox="1"/>
            <p:nvPr/>
          </p:nvSpPr>
          <p:spPr>
            <a:xfrm>
              <a:off x="2803895" y="1086903"/>
              <a:ext cx="208973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err="1">
                  <a:latin typeface="Times New Roman" pitchFamily="18" charset="0"/>
                  <a:cs typeface="Times New Roman" pitchFamily="18" charset="0"/>
                </a:rPr>
                <a:t>Measurement</a:t>
              </a:r>
              <a:r>
                <a:rPr lang="fr-FR" sz="1000" dirty="0">
                  <a:latin typeface="Times New Roman" pitchFamily="18" charset="0"/>
                  <a:cs typeface="Times New Roman" pitchFamily="18" charset="0"/>
                </a:rPr>
                <a:t> of fluorescence signals</a:t>
              </a:r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1202703" y="194148"/>
              <a:ext cx="8258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err="1">
                  <a:latin typeface="Times New Roman" pitchFamily="18" charset="0"/>
                  <a:cs typeface="Times New Roman" pitchFamily="18" charset="0"/>
                </a:rPr>
                <a:t>Cell</a:t>
              </a:r>
              <a:r>
                <a:rPr lang="fr-FR" sz="1000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fr-FR" sz="1000" dirty="0" err="1">
                  <a:latin typeface="Times New Roman" pitchFamily="18" charset="0"/>
                  <a:cs typeface="Times New Roman" pitchFamily="18" charset="0"/>
                </a:rPr>
                <a:t>seeding</a:t>
              </a:r>
              <a:endParaRPr lang="fr-FR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" name="Line 17"/>
            <p:cNvSpPr>
              <a:spLocks noChangeShapeType="1"/>
            </p:cNvSpPr>
            <p:nvPr/>
          </p:nvSpPr>
          <p:spPr bwMode="auto">
            <a:xfrm>
              <a:off x="1741602" y="446835"/>
              <a:ext cx="0" cy="268920"/>
            </a:xfrm>
            <a:prstGeom prst="line">
              <a:avLst/>
            </a:prstGeom>
            <a:ln>
              <a:headEnd/>
              <a:tailEnd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/>
            <a:lstStyle/>
            <a:p>
              <a:pPr algn="ctr"/>
              <a:endParaRPr lang="fr-FR" sz="12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" name="Accolade ouvrante 16"/>
            <p:cNvSpPr/>
            <p:nvPr/>
          </p:nvSpPr>
          <p:spPr>
            <a:xfrm rot="16200000" flipV="1">
              <a:off x="3796894" y="-554398"/>
              <a:ext cx="131886" cy="3195996"/>
            </a:xfrm>
            <a:prstGeom prst="leftBrace">
              <a:avLst>
                <a:gd name="adj1" fmla="val 101751"/>
                <a:gd name="adj2" fmla="val 50671"/>
              </a:avLst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grpSp>
          <p:nvGrpSpPr>
            <p:cNvPr id="18" name="Groupe 17"/>
            <p:cNvGrpSpPr/>
            <p:nvPr/>
          </p:nvGrpSpPr>
          <p:grpSpPr>
            <a:xfrm>
              <a:off x="3404822" y="1234501"/>
              <a:ext cx="879634" cy="890082"/>
              <a:chOff x="3916148" y="6064796"/>
              <a:chExt cx="1210127" cy="1180060"/>
            </a:xfrm>
          </p:grpSpPr>
          <p:sp>
            <p:nvSpPr>
              <p:cNvPr id="28" name="Oval 40" descr="Pointillés"/>
              <p:cNvSpPr>
                <a:spLocks noChangeArrowheads="1"/>
              </p:cNvSpPr>
              <p:nvPr/>
            </p:nvSpPr>
            <p:spPr bwMode="auto">
              <a:xfrm rot="1947442">
                <a:off x="3916148" y="6064796"/>
                <a:ext cx="1210127" cy="1180060"/>
              </a:xfrm>
              <a:prstGeom prst="ellipse">
                <a:avLst/>
              </a:prstGeom>
              <a:pattFill prst="smConfetti">
                <a:fgClr>
                  <a:schemeClr val="bg1"/>
                </a:fgClr>
                <a:bgClr>
                  <a:srgbClr val="FF0000"/>
                </a:bgClr>
              </a:pattFill>
              <a:ln w="9525">
                <a:solidFill>
                  <a:schemeClr val="bg1"/>
                </a:solidFill>
                <a:round/>
                <a:headEnd/>
                <a:tailEnd/>
              </a:ln>
              <a:effectLst>
                <a:outerShdw blurRad="127000" dist="38100" dir="2700000" algn="ctr">
                  <a:srgbClr val="000000">
                    <a:alpha val="45000"/>
                  </a:srgbClr>
                </a:outerShdw>
              </a:effectLst>
              <a:scene3d>
                <a:camera prst="perspectiveFront" fov="2700000">
                  <a:rot lat="20376000" lon="1938000" rev="20112001"/>
                </a:camera>
                <a:lightRig rig="threePt" dir="t">
                  <a:rot lat="0" lon="0" rev="0"/>
                </a:lightRig>
              </a:scene3d>
              <a:sp3d>
                <a:bevelT w="203200" h="50800"/>
                <a:bevelB w="152400" h="50800" prst="softRound"/>
              </a:sp3d>
            </p:spPr>
            <p:txBody>
              <a:bodyPr wrap="none" anchor="ctr"/>
              <a:lstStyle/>
              <a:p>
                <a:pPr algn="ctr"/>
                <a:endParaRPr lang="fr-FR"/>
              </a:p>
            </p:txBody>
          </p:sp>
          <p:sp>
            <p:nvSpPr>
              <p:cNvPr id="29" name="Forme libre 28"/>
              <p:cNvSpPr/>
              <p:nvPr/>
            </p:nvSpPr>
            <p:spPr>
              <a:xfrm rot="1845285">
                <a:off x="4122308" y="6324800"/>
                <a:ext cx="711556" cy="582827"/>
              </a:xfrm>
              <a:custGeom>
                <a:avLst/>
                <a:gdLst>
                  <a:gd name="connsiteX0" fmla="*/ 138796 w 957503"/>
                  <a:gd name="connsiteY0" fmla="*/ 255182 h 829422"/>
                  <a:gd name="connsiteX1" fmla="*/ 245122 w 957503"/>
                  <a:gd name="connsiteY1" fmla="*/ 148856 h 829422"/>
                  <a:gd name="connsiteX2" fmla="*/ 308917 w 957503"/>
                  <a:gd name="connsiteY2" fmla="*/ 74428 h 829422"/>
                  <a:gd name="connsiteX3" fmla="*/ 340815 w 957503"/>
                  <a:gd name="connsiteY3" fmla="*/ 63796 h 829422"/>
                  <a:gd name="connsiteX4" fmla="*/ 372713 w 957503"/>
                  <a:gd name="connsiteY4" fmla="*/ 42531 h 829422"/>
                  <a:gd name="connsiteX5" fmla="*/ 415243 w 957503"/>
                  <a:gd name="connsiteY5" fmla="*/ 21266 h 829422"/>
                  <a:gd name="connsiteX6" fmla="*/ 436508 w 957503"/>
                  <a:gd name="connsiteY6" fmla="*/ 0 h 829422"/>
                  <a:gd name="connsiteX7" fmla="*/ 542834 w 957503"/>
                  <a:gd name="connsiteY7" fmla="*/ 31898 h 829422"/>
                  <a:gd name="connsiteX8" fmla="*/ 574731 w 957503"/>
                  <a:gd name="connsiteY8" fmla="*/ 42531 h 829422"/>
                  <a:gd name="connsiteX9" fmla="*/ 606629 w 957503"/>
                  <a:gd name="connsiteY9" fmla="*/ 53163 h 829422"/>
                  <a:gd name="connsiteX10" fmla="*/ 723587 w 957503"/>
                  <a:gd name="connsiteY10" fmla="*/ 95693 h 829422"/>
                  <a:gd name="connsiteX11" fmla="*/ 851178 w 957503"/>
                  <a:gd name="connsiteY11" fmla="*/ 116959 h 829422"/>
                  <a:gd name="connsiteX12" fmla="*/ 925606 w 957503"/>
                  <a:gd name="connsiteY12" fmla="*/ 191386 h 829422"/>
                  <a:gd name="connsiteX13" fmla="*/ 936238 w 957503"/>
                  <a:gd name="connsiteY13" fmla="*/ 233917 h 829422"/>
                  <a:gd name="connsiteX14" fmla="*/ 925606 w 957503"/>
                  <a:gd name="connsiteY14" fmla="*/ 329610 h 829422"/>
                  <a:gd name="connsiteX15" fmla="*/ 893708 w 957503"/>
                  <a:gd name="connsiteY15" fmla="*/ 340242 h 829422"/>
                  <a:gd name="connsiteX16" fmla="*/ 861810 w 957503"/>
                  <a:gd name="connsiteY16" fmla="*/ 382772 h 829422"/>
                  <a:gd name="connsiteX17" fmla="*/ 851178 w 957503"/>
                  <a:gd name="connsiteY17" fmla="*/ 414670 h 829422"/>
                  <a:gd name="connsiteX18" fmla="*/ 883076 w 957503"/>
                  <a:gd name="connsiteY18" fmla="*/ 574159 h 829422"/>
                  <a:gd name="connsiteX19" fmla="*/ 893708 w 957503"/>
                  <a:gd name="connsiteY19" fmla="*/ 616689 h 829422"/>
                  <a:gd name="connsiteX20" fmla="*/ 925606 w 957503"/>
                  <a:gd name="connsiteY20" fmla="*/ 637954 h 829422"/>
                  <a:gd name="connsiteX21" fmla="*/ 957503 w 957503"/>
                  <a:gd name="connsiteY21" fmla="*/ 786810 h 829422"/>
                  <a:gd name="connsiteX22" fmla="*/ 946871 w 957503"/>
                  <a:gd name="connsiteY22" fmla="*/ 818707 h 829422"/>
                  <a:gd name="connsiteX23" fmla="*/ 840545 w 957503"/>
                  <a:gd name="connsiteY23" fmla="*/ 818707 h 829422"/>
                  <a:gd name="connsiteX24" fmla="*/ 776750 w 957503"/>
                  <a:gd name="connsiteY24" fmla="*/ 776177 h 829422"/>
                  <a:gd name="connsiteX25" fmla="*/ 691689 w 957503"/>
                  <a:gd name="connsiteY25" fmla="*/ 648586 h 829422"/>
                  <a:gd name="connsiteX26" fmla="*/ 659792 w 957503"/>
                  <a:gd name="connsiteY26" fmla="*/ 659219 h 829422"/>
                  <a:gd name="connsiteX27" fmla="*/ 585364 w 957503"/>
                  <a:gd name="connsiteY27" fmla="*/ 680484 h 829422"/>
                  <a:gd name="connsiteX28" fmla="*/ 532201 w 957503"/>
                  <a:gd name="connsiteY28" fmla="*/ 723014 h 829422"/>
                  <a:gd name="connsiteX29" fmla="*/ 500303 w 957503"/>
                  <a:gd name="connsiteY29" fmla="*/ 744279 h 829422"/>
                  <a:gd name="connsiteX30" fmla="*/ 436508 w 957503"/>
                  <a:gd name="connsiteY30" fmla="*/ 765545 h 829422"/>
                  <a:gd name="connsiteX31" fmla="*/ 404610 w 957503"/>
                  <a:gd name="connsiteY31" fmla="*/ 776177 h 829422"/>
                  <a:gd name="connsiteX32" fmla="*/ 362080 w 957503"/>
                  <a:gd name="connsiteY32" fmla="*/ 765545 h 829422"/>
                  <a:gd name="connsiteX33" fmla="*/ 213224 w 957503"/>
                  <a:gd name="connsiteY33" fmla="*/ 680484 h 829422"/>
                  <a:gd name="connsiteX34" fmla="*/ 181327 w 957503"/>
                  <a:gd name="connsiteY34" fmla="*/ 648586 h 829422"/>
                  <a:gd name="connsiteX35" fmla="*/ 128164 w 957503"/>
                  <a:gd name="connsiteY35" fmla="*/ 542261 h 829422"/>
                  <a:gd name="connsiteX36" fmla="*/ 96266 w 957503"/>
                  <a:gd name="connsiteY36" fmla="*/ 510363 h 829422"/>
                  <a:gd name="connsiteX37" fmla="*/ 32471 w 957503"/>
                  <a:gd name="connsiteY37" fmla="*/ 489098 h 829422"/>
                  <a:gd name="connsiteX38" fmla="*/ 573 w 957503"/>
                  <a:gd name="connsiteY38" fmla="*/ 457200 h 829422"/>
                  <a:gd name="connsiteX39" fmla="*/ 21838 w 957503"/>
                  <a:gd name="connsiteY39" fmla="*/ 329610 h 829422"/>
                  <a:gd name="connsiteX40" fmla="*/ 43103 w 957503"/>
                  <a:gd name="connsiteY40" fmla="*/ 297712 h 829422"/>
                  <a:gd name="connsiteX41" fmla="*/ 75001 w 957503"/>
                  <a:gd name="connsiteY41" fmla="*/ 287079 h 829422"/>
                  <a:gd name="connsiteX42" fmla="*/ 138796 w 957503"/>
                  <a:gd name="connsiteY42" fmla="*/ 255182 h 82942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</a:cxnLst>
                <a:rect l="l" t="t" r="r" b="b"/>
                <a:pathLst>
                  <a:path w="957503" h="829422">
                    <a:moveTo>
                      <a:pt x="138796" y="255182"/>
                    </a:moveTo>
                    <a:cubicBezTo>
                      <a:pt x="167150" y="232145"/>
                      <a:pt x="209680" y="184298"/>
                      <a:pt x="245122" y="148856"/>
                    </a:cubicBezTo>
                    <a:cubicBezTo>
                      <a:pt x="274596" y="119382"/>
                      <a:pt x="274202" y="97572"/>
                      <a:pt x="308917" y="74428"/>
                    </a:cubicBezTo>
                    <a:cubicBezTo>
                      <a:pt x="318242" y="68211"/>
                      <a:pt x="330182" y="67340"/>
                      <a:pt x="340815" y="63796"/>
                    </a:cubicBezTo>
                    <a:cubicBezTo>
                      <a:pt x="351448" y="56708"/>
                      <a:pt x="361618" y="48871"/>
                      <a:pt x="372713" y="42531"/>
                    </a:cubicBezTo>
                    <a:cubicBezTo>
                      <a:pt x="386475" y="34667"/>
                      <a:pt x="402055" y="30058"/>
                      <a:pt x="415243" y="21266"/>
                    </a:cubicBezTo>
                    <a:cubicBezTo>
                      <a:pt x="423584" y="15705"/>
                      <a:pt x="429420" y="7089"/>
                      <a:pt x="436508" y="0"/>
                    </a:cubicBezTo>
                    <a:cubicBezTo>
                      <a:pt x="500779" y="16068"/>
                      <a:pt x="465183" y="6014"/>
                      <a:pt x="542834" y="31898"/>
                    </a:cubicBezTo>
                    <a:lnTo>
                      <a:pt x="574731" y="42531"/>
                    </a:lnTo>
                    <a:cubicBezTo>
                      <a:pt x="585364" y="46075"/>
                      <a:pt x="596223" y="49001"/>
                      <a:pt x="606629" y="53163"/>
                    </a:cubicBezTo>
                    <a:cubicBezTo>
                      <a:pt x="634113" y="64156"/>
                      <a:pt x="696286" y="90233"/>
                      <a:pt x="723587" y="95693"/>
                    </a:cubicBezTo>
                    <a:cubicBezTo>
                      <a:pt x="801325" y="111241"/>
                      <a:pt x="758860" y="103770"/>
                      <a:pt x="851178" y="116959"/>
                    </a:cubicBezTo>
                    <a:cubicBezTo>
                      <a:pt x="934353" y="144684"/>
                      <a:pt x="908774" y="115643"/>
                      <a:pt x="925606" y="191386"/>
                    </a:cubicBezTo>
                    <a:cubicBezTo>
                      <a:pt x="928776" y="205651"/>
                      <a:pt x="932694" y="219740"/>
                      <a:pt x="936238" y="233917"/>
                    </a:cubicBezTo>
                    <a:cubicBezTo>
                      <a:pt x="932694" y="265815"/>
                      <a:pt x="937525" y="299812"/>
                      <a:pt x="925606" y="329610"/>
                    </a:cubicBezTo>
                    <a:cubicBezTo>
                      <a:pt x="921444" y="340016"/>
                      <a:pt x="902318" y="333067"/>
                      <a:pt x="893708" y="340242"/>
                    </a:cubicBezTo>
                    <a:cubicBezTo>
                      <a:pt x="880094" y="351586"/>
                      <a:pt x="872443" y="368595"/>
                      <a:pt x="861810" y="382772"/>
                    </a:cubicBezTo>
                    <a:cubicBezTo>
                      <a:pt x="858266" y="393405"/>
                      <a:pt x="851178" y="403462"/>
                      <a:pt x="851178" y="414670"/>
                    </a:cubicBezTo>
                    <a:cubicBezTo>
                      <a:pt x="851178" y="503947"/>
                      <a:pt x="860815" y="499957"/>
                      <a:pt x="883076" y="574159"/>
                    </a:cubicBezTo>
                    <a:cubicBezTo>
                      <a:pt x="887275" y="588156"/>
                      <a:pt x="885602" y="604530"/>
                      <a:pt x="893708" y="616689"/>
                    </a:cubicBezTo>
                    <a:cubicBezTo>
                      <a:pt x="900796" y="627322"/>
                      <a:pt x="914973" y="630866"/>
                      <a:pt x="925606" y="637954"/>
                    </a:cubicBezTo>
                    <a:cubicBezTo>
                      <a:pt x="949737" y="758608"/>
                      <a:pt x="938105" y="709214"/>
                      <a:pt x="957503" y="786810"/>
                    </a:cubicBezTo>
                    <a:cubicBezTo>
                      <a:pt x="953959" y="797442"/>
                      <a:pt x="955622" y="811706"/>
                      <a:pt x="946871" y="818707"/>
                    </a:cubicBezTo>
                    <a:cubicBezTo>
                      <a:pt x="919523" y="840585"/>
                      <a:pt x="865501" y="822866"/>
                      <a:pt x="840545" y="818707"/>
                    </a:cubicBezTo>
                    <a:cubicBezTo>
                      <a:pt x="819280" y="804530"/>
                      <a:pt x="784832" y="800423"/>
                      <a:pt x="776750" y="776177"/>
                    </a:cubicBezTo>
                    <a:cubicBezTo>
                      <a:pt x="738317" y="660878"/>
                      <a:pt x="773684" y="697783"/>
                      <a:pt x="691689" y="648586"/>
                    </a:cubicBezTo>
                    <a:cubicBezTo>
                      <a:pt x="681057" y="652130"/>
                      <a:pt x="670568" y="656140"/>
                      <a:pt x="659792" y="659219"/>
                    </a:cubicBezTo>
                    <a:cubicBezTo>
                      <a:pt x="566302" y="685932"/>
                      <a:pt x="661871" y="654983"/>
                      <a:pt x="585364" y="680484"/>
                    </a:cubicBezTo>
                    <a:cubicBezTo>
                      <a:pt x="549517" y="734256"/>
                      <a:pt x="583559" y="697336"/>
                      <a:pt x="532201" y="723014"/>
                    </a:cubicBezTo>
                    <a:cubicBezTo>
                      <a:pt x="520771" y="728729"/>
                      <a:pt x="511980" y="739089"/>
                      <a:pt x="500303" y="744279"/>
                    </a:cubicBezTo>
                    <a:cubicBezTo>
                      <a:pt x="479820" y="753383"/>
                      <a:pt x="457773" y="758457"/>
                      <a:pt x="436508" y="765545"/>
                    </a:cubicBezTo>
                    <a:lnTo>
                      <a:pt x="404610" y="776177"/>
                    </a:lnTo>
                    <a:cubicBezTo>
                      <a:pt x="390433" y="772633"/>
                      <a:pt x="375648" y="770972"/>
                      <a:pt x="362080" y="765545"/>
                    </a:cubicBezTo>
                    <a:cubicBezTo>
                      <a:pt x="310027" y="744724"/>
                      <a:pt x="259874" y="709640"/>
                      <a:pt x="213224" y="680484"/>
                    </a:cubicBezTo>
                    <a:cubicBezTo>
                      <a:pt x="200473" y="672515"/>
                      <a:pt x="191959" y="659219"/>
                      <a:pt x="181327" y="648586"/>
                    </a:cubicBezTo>
                    <a:cubicBezTo>
                      <a:pt x="165118" y="518917"/>
                      <a:pt x="198254" y="592325"/>
                      <a:pt x="128164" y="542261"/>
                    </a:cubicBezTo>
                    <a:cubicBezTo>
                      <a:pt x="115928" y="533521"/>
                      <a:pt x="109411" y="517666"/>
                      <a:pt x="96266" y="510363"/>
                    </a:cubicBezTo>
                    <a:cubicBezTo>
                      <a:pt x="76672" y="499477"/>
                      <a:pt x="32471" y="489098"/>
                      <a:pt x="32471" y="489098"/>
                    </a:cubicBezTo>
                    <a:cubicBezTo>
                      <a:pt x="21838" y="478465"/>
                      <a:pt x="3045" y="472032"/>
                      <a:pt x="573" y="457200"/>
                    </a:cubicBezTo>
                    <a:cubicBezTo>
                      <a:pt x="-2374" y="439517"/>
                      <a:pt x="6232" y="360823"/>
                      <a:pt x="21838" y="329610"/>
                    </a:cubicBezTo>
                    <a:cubicBezTo>
                      <a:pt x="27553" y="318180"/>
                      <a:pt x="33124" y="305695"/>
                      <a:pt x="43103" y="297712"/>
                    </a:cubicBezTo>
                    <a:cubicBezTo>
                      <a:pt x="51855" y="290710"/>
                      <a:pt x="64368" y="290623"/>
                      <a:pt x="75001" y="287079"/>
                    </a:cubicBezTo>
                    <a:cubicBezTo>
                      <a:pt x="100198" y="249284"/>
                      <a:pt x="110442" y="278219"/>
                      <a:pt x="138796" y="255182"/>
                    </a:cubicBezTo>
                    <a:close/>
                  </a:path>
                </a:pathLst>
              </a:custGeom>
              <a:pattFill prst="smConfetti">
                <a:fgClr>
                  <a:schemeClr val="bg1"/>
                </a:fgClr>
                <a:bgClr>
                  <a:srgbClr val="007434"/>
                </a:bgClr>
              </a:pattFill>
              <a:ln w="3175">
                <a:noFill/>
              </a:ln>
              <a:effectLst>
                <a:outerShdw sx="1000" sy="1000" algn="ctr">
                  <a:srgbClr val="00602B"/>
                </a:outerShdw>
              </a:effectLst>
              <a:scene3d>
                <a:camera prst="perspectiveFront" fov="2700000">
                  <a:rot lat="20376000" lon="1938000" rev="20112001"/>
                </a:camera>
                <a:lightRig rig="threePt" dir="t">
                  <a:rot lat="0" lon="0" rev="0"/>
                </a:lightRig>
              </a:scene3d>
              <a:sp3d prstMaterial="matte">
                <a:bevelT w="203200" h="50800" prst="coolSlant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30" name="Oval 47" descr="Pointillés"/>
              <p:cNvSpPr>
                <a:spLocks noChangeAspect="1" noChangeArrowheads="1"/>
              </p:cNvSpPr>
              <p:nvPr/>
            </p:nvSpPr>
            <p:spPr bwMode="auto">
              <a:xfrm rot="1947442">
                <a:off x="4374175" y="6247208"/>
                <a:ext cx="84535" cy="82770"/>
              </a:xfrm>
              <a:prstGeom prst="ellipse">
                <a:avLst/>
              </a:prstGeom>
              <a:pattFill prst="smConfetti">
                <a:fgClr>
                  <a:schemeClr val="bg1"/>
                </a:fgClr>
                <a:bgClr>
                  <a:srgbClr val="00602B"/>
                </a:bgClr>
              </a:pattFill>
              <a:ln w="19050">
                <a:noFill/>
                <a:round/>
                <a:headEnd/>
                <a:tailEnd/>
              </a:ln>
              <a:effectLst>
                <a:outerShdw blurRad="127000" dist="38100" dir="2700000" algn="ctr">
                  <a:srgbClr val="000000">
                    <a:alpha val="45000"/>
                  </a:srgbClr>
                </a:outerShdw>
              </a:effectLst>
              <a:scene3d>
                <a:camera prst="perspectiveFront" fov="2700000">
                  <a:rot lat="20376000" lon="1938000" rev="20112001"/>
                </a:camera>
                <a:lightRig rig="threePt" dir="t">
                  <a:rot lat="0" lon="0" rev="0"/>
                </a:lightRig>
              </a:scene3d>
              <a:sp3d>
                <a:bevelT w="203200" h="50800"/>
                <a:bevelB w="152400" h="50800" prst="softRound"/>
              </a:sp3d>
            </p:spPr>
            <p:txBody>
              <a:bodyPr wrap="none" anchor="ctr"/>
              <a:lstStyle/>
              <a:p>
                <a:pPr algn="ctr"/>
                <a:endParaRPr lang="fr-FR"/>
              </a:p>
            </p:txBody>
          </p:sp>
          <p:sp>
            <p:nvSpPr>
              <p:cNvPr id="32" name="Oval 49" descr="Pointillés"/>
              <p:cNvSpPr>
                <a:spLocks noChangeAspect="1" noChangeArrowheads="1"/>
              </p:cNvSpPr>
              <p:nvPr/>
            </p:nvSpPr>
            <p:spPr bwMode="auto">
              <a:xfrm rot="1947442">
                <a:off x="4265157" y="6500070"/>
                <a:ext cx="84478" cy="82235"/>
              </a:xfrm>
              <a:prstGeom prst="ellipse">
                <a:avLst/>
              </a:prstGeom>
              <a:pattFill prst="smConfetti">
                <a:fgClr>
                  <a:schemeClr val="bg1"/>
                </a:fgClr>
                <a:bgClr>
                  <a:srgbClr val="FF0000"/>
                </a:bgClr>
              </a:pattFill>
              <a:ln w="19050">
                <a:noFill/>
                <a:round/>
                <a:headEnd/>
                <a:tailEnd/>
              </a:ln>
              <a:effectLst>
                <a:outerShdw blurRad="127000" dist="38100" dir="2700000" algn="ctr">
                  <a:srgbClr val="000000">
                    <a:alpha val="45000"/>
                  </a:srgbClr>
                </a:outerShdw>
              </a:effectLst>
              <a:scene3d>
                <a:camera prst="perspectiveFront" fov="2700000">
                  <a:rot lat="20376000" lon="1938000" rev="20112001"/>
                </a:camera>
                <a:lightRig rig="threePt" dir="t">
                  <a:rot lat="0" lon="0" rev="0"/>
                </a:lightRig>
              </a:scene3d>
              <a:sp3d>
                <a:bevelT w="203200" h="50800"/>
                <a:bevelB w="152400" h="50800" prst="softRound"/>
              </a:sp3d>
            </p:spPr>
            <p:txBody>
              <a:bodyPr wrap="none" anchor="ctr"/>
              <a:lstStyle/>
              <a:p>
                <a:pPr algn="ctr"/>
                <a:endParaRPr lang="fr-FR"/>
              </a:p>
            </p:txBody>
          </p:sp>
          <p:sp>
            <p:nvSpPr>
              <p:cNvPr id="34" name="Oval 49" descr="Pointillés"/>
              <p:cNvSpPr>
                <a:spLocks noChangeAspect="1" noChangeArrowheads="1"/>
              </p:cNvSpPr>
              <p:nvPr/>
            </p:nvSpPr>
            <p:spPr bwMode="auto">
              <a:xfrm rot="1947442">
                <a:off x="4325962" y="6637986"/>
                <a:ext cx="84478" cy="82235"/>
              </a:xfrm>
              <a:prstGeom prst="ellipse">
                <a:avLst/>
              </a:prstGeom>
              <a:pattFill prst="smConfetti">
                <a:fgClr>
                  <a:schemeClr val="bg1"/>
                </a:fgClr>
                <a:bgClr>
                  <a:srgbClr val="FF0000"/>
                </a:bgClr>
              </a:pattFill>
              <a:ln w="19050">
                <a:noFill/>
                <a:round/>
                <a:headEnd/>
                <a:tailEnd/>
              </a:ln>
              <a:effectLst>
                <a:outerShdw blurRad="127000" dist="38100" dir="2700000" algn="ctr">
                  <a:srgbClr val="000000">
                    <a:alpha val="45000"/>
                  </a:srgbClr>
                </a:outerShdw>
              </a:effectLst>
              <a:scene3d>
                <a:camera prst="perspectiveFront" fov="2700000">
                  <a:rot lat="20376000" lon="1938000" rev="20112001"/>
                </a:camera>
                <a:lightRig rig="threePt" dir="t">
                  <a:rot lat="0" lon="0" rev="0"/>
                </a:lightRig>
              </a:scene3d>
              <a:sp3d>
                <a:bevelT w="203200" h="50800"/>
                <a:bevelB w="152400" h="50800" prst="softRound"/>
              </a:sp3d>
            </p:spPr>
            <p:txBody>
              <a:bodyPr wrap="none" anchor="ctr"/>
              <a:lstStyle/>
              <a:p>
                <a:pPr algn="ctr"/>
                <a:endParaRPr lang="fr-FR"/>
              </a:p>
            </p:txBody>
          </p:sp>
        </p:grpSp>
        <p:pic>
          <p:nvPicPr>
            <p:cNvPr id="20" name="Picture 14"/>
            <p:cNvPicPr>
              <a:picLocks noChangeAspect="1" noChangeArrowheads="1"/>
            </p:cNvPicPr>
            <p:nvPr/>
          </p:nvPicPr>
          <p:blipFill rotWithShape="1">
            <a:blip r:embed="rId5"/>
            <a:srcRect t="3710" b="10492"/>
            <a:stretch/>
          </p:blipFill>
          <p:spPr bwMode="auto">
            <a:xfrm>
              <a:off x="2251004" y="2174160"/>
              <a:ext cx="936000" cy="8362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1" name="Picture 10"/>
            <p:cNvPicPr>
              <a:picLocks noChangeAspect="1" noChangeArrowheads="1"/>
            </p:cNvPicPr>
            <p:nvPr/>
          </p:nvPicPr>
          <p:blipFill>
            <a:blip r:embed="rId6"/>
            <a:srcRect b="7045"/>
            <a:stretch>
              <a:fillRect/>
            </a:stretch>
          </p:blipFill>
          <p:spPr bwMode="auto">
            <a:xfrm>
              <a:off x="1128466" y="2174021"/>
              <a:ext cx="928660" cy="8365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3" name="Line 17"/>
            <p:cNvSpPr>
              <a:spLocks noChangeShapeType="1"/>
            </p:cNvSpPr>
            <p:nvPr/>
          </p:nvSpPr>
          <p:spPr bwMode="auto">
            <a:xfrm>
              <a:off x="2220546" y="1603180"/>
              <a:ext cx="397076" cy="638987"/>
            </a:xfrm>
            <a:prstGeom prst="line">
              <a:avLst/>
            </a:prstGeom>
            <a:ln w="12700">
              <a:prstDash val="sysDash"/>
              <a:headEnd/>
              <a:tailEnd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/>
            <a:lstStyle/>
            <a:p>
              <a:pPr algn="ctr"/>
              <a:endParaRPr lang="fr-FR" sz="12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" name="Line 17"/>
            <p:cNvSpPr>
              <a:spLocks noChangeShapeType="1"/>
            </p:cNvSpPr>
            <p:nvPr/>
          </p:nvSpPr>
          <p:spPr bwMode="auto">
            <a:xfrm flipH="1">
              <a:off x="1676255" y="1875732"/>
              <a:ext cx="285169" cy="336045"/>
            </a:xfrm>
            <a:prstGeom prst="line">
              <a:avLst/>
            </a:prstGeom>
            <a:ln w="12700">
              <a:prstDash val="sysDash"/>
              <a:headEnd/>
              <a:tailEnd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/>
            <a:lstStyle/>
            <a:p>
              <a:pPr algn="ctr"/>
              <a:endParaRPr lang="fr-FR" sz="12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8" name="Line 17"/>
            <p:cNvSpPr>
              <a:spLocks noChangeShapeType="1"/>
            </p:cNvSpPr>
            <p:nvPr/>
          </p:nvSpPr>
          <p:spPr bwMode="auto">
            <a:xfrm flipH="1">
              <a:off x="1484783" y="1619726"/>
              <a:ext cx="429185" cy="0"/>
            </a:xfrm>
            <a:prstGeom prst="line">
              <a:avLst/>
            </a:prstGeom>
            <a:ln w="12700">
              <a:prstDash val="sysDash"/>
              <a:headEnd/>
              <a:tailEnd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/>
            <a:lstStyle/>
            <a:p>
              <a:pPr algn="ctr"/>
              <a:endParaRPr lang="fr-FR" sz="12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9" name="Text Box 10"/>
            <p:cNvSpPr txBox="1">
              <a:spLocks noChangeArrowheads="1"/>
            </p:cNvSpPr>
            <p:nvPr/>
          </p:nvSpPr>
          <p:spPr bwMode="auto">
            <a:xfrm>
              <a:off x="1059894" y="1466419"/>
              <a:ext cx="47961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fr-FR" sz="1000" dirty="0">
                  <a:latin typeface="Times New Roman" pitchFamily="18" charset="0"/>
                  <a:cs typeface="Times New Roman" pitchFamily="18" charset="0"/>
                </a:rPr>
                <a:t>Insert</a:t>
              </a:r>
            </a:p>
          </p:txBody>
        </p:sp>
        <p:grpSp>
          <p:nvGrpSpPr>
            <p:cNvPr id="60" name="Groupe 17"/>
            <p:cNvGrpSpPr/>
            <p:nvPr/>
          </p:nvGrpSpPr>
          <p:grpSpPr>
            <a:xfrm>
              <a:off x="5050624" y="1234501"/>
              <a:ext cx="879634" cy="890082"/>
              <a:chOff x="3916148" y="6064796"/>
              <a:chExt cx="1210127" cy="1180060"/>
            </a:xfrm>
          </p:grpSpPr>
          <p:sp>
            <p:nvSpPr>
              <p:cNvPr id="61" name="Oval 40" descr="Pointillés"/>
              <p:cNvSpPr>
                <a:spLocks noChangeArrowheads="1"/>
              </p:cNvSpPr>
              <p:nvPr/>
            </p:nvSpPr>
            <p:spPr bwMode="auto">
              <a:xfrm rot="1947442">
                <a:off x="3916148" y="6064796"/>
                <a:ext cx="1210127" cy="1180060"/>
              </a:xfrm>
              <a:prstGeom prst="ellipse">
                <a:avLst/>
              </a:prstGeom>
              <a:pattFill prst="smConfetti">
                <a:fgClr>
                  <a:schemeClr val="bg1"/>
                </a:fgClr>
                <a:bgClr>
                  <a:srgbClr val="FF0000"/>
                </a:bgClr>
              </a:pattFill>
              <a:ln w="9525">
                <a:solidFill>
                  <a:schemeClr val="bg1"/>
                </a:solidFill>
                <a:round/>
                <a:headEnd/>
                <a:tailEnd/>
              </a:ln>
              <a:effectLst>
                <a:outerShdw blurRad="127000" dist="38100" dir="2700000" algn="ctr">
                  <a:srgbClr val="000000">
                    <a:alpha val="45000"/>
                  </a:srgbClr>
                </a:outerShdw>
              </a:effectLst>
              <a:scene3d>
                <a:camera prst="perspectiveFront" fov="2700000">
                  <a:rot lat="20376000" lon="1938000" rev="20112001"/>
                </a:camera>
                <a:lightRig rig="threePt" dir="t">
                  <a:rot lat="0" lon="0" rev="0"/>
                </a:lightRig>
              </a:scene3d>
              <a:sp3d>
                <a:bevelT w="203200" h="50800"/>
                <a:bevelB w="152400" h="50800" prst="softRound"/>
              </a:sp3d>
            </p:spPr>
            <p:txBody>
              <a:bodyPr wrap="none" anchor="ctr"/>
              <a:lstStyle/>
              <a:p>
                <a:pPr algn="ctr"/>
                <a:endParaRPr lang="fr-FR"/>
              </a:p>
            </p:txBody>
          </p:sp>
          <p:sp>
            <p:nvSpPr>
              <p:cNvPr id="62" name="Forme libre 61"/>
              <p:cNvSpPr/>
              <p:nvPr/>
            </p:nvSpPr>
            <p:spPr>
              <a:xfrm rot="1845285">
                <a:off x="4318848" y="6410068"/>
                <a:ext cx="445797" cy="236291"/>
              </a:xfrm>
              <a:custGeom>
                <a:avLst/>
                <a:gdLst>
                  <a:gd name="connsiteX0" fmla="*/ 138796 w 957503"/>
                  <a:gd name="connsiteY0" fmla="*/ 255182 h 829422"/>
                  <a:gd name="connsiteX1" fmla="*/ 245122 w 957503"/>
                  <a:gd name="connsiteY1" fmla="*/ 148856 h 829422"/>
                  <a:gd name="connsiteX2" fmla="*/ 308917 w 957503"/>
                  <a:gd name="connsiteY2" fmla="*/ 74428 h 829422"/>
                  <a:gd name="connsiteX3" fmla="*/ 340815 w 957503"/>
                  <a:gd name="connsiteY3" fmla="*/ 63796 h 829422"/>
                  <a:gd name="connsiteX4" fmla="*/ 372713 w 957503"/>
                  <a:gd name="connsiteY4" fmla="*/ 42531 h 829422"/>
                  <a:gd name="connsiteX5" fmla="*/ 415243 w 957503"/>
                  <a:gd name="connsiteY5" fmla="*/ 21266 h 829422"/>
                  <a:gd name="connsiteX6" fmla="*/ 436508 w 957503"/>
                  <a:gd name="connsiteY6" fmla="*/ 0 h 829422"/>
                  <a:gd name="connsiteX7" fmla="*/ 542834 w 957503"/>
                  <a:gd name="connsiteY7" fmla="*/ 31898 h 829422"/>
                  <a:gd name="connsiteX8" fmla="*/ 574731 w 957503"/>
                  <a:gd name="connsiteY8" fmla="*/ 42531 h 829422"/>
                  <a:gd name="connsiteX9" fmla="*/ 606629 w 957503"/>
                  <a:gd name="connsiteY9" fmla="*/ 53163 h 829422"/>
                  <a:gd name="connsiteX10" fmla="*/ 723587 w 957503"/>
                  <a:gd name="connsiteY10" fmla="*/ 95693 h 829422"/>
                  <a:gd name="connsiteX11" fmla="*/ 851178 w 957503"/>
                  <a:gd name="connsiteY11" fmla="*/ 116959 h 829422"/>
                  <a:gd name="connsiteX12" fmla="*/ 925606 w 957503"/>
                  <a:gd name="connsiteY12" fmla="*/ 191386 h 829422"/>
                  <a:gd name="connsiteX13" fmla="*/ 936238 w 957503"/>
                  <a:gd name="connsiteY13" fmla="*/ 233917 h 829422"/>
                  <a:gd name="connsiteX14" fmla="*/ 925606 w 957503"/>
                  <a:gd name="connsiteY14" fmla="*/ 329610 h 829422"/>
                  <a:gd name="connsiteX15" fmla="*/ 893708 w 957503"/>
                  <a:gd name="connsiteY15" fmla="*/ 340242 h 829422"/>
                  <a:gd name="connsiteX16" fmla="*/ 861810 w 957503"/>
                  <a:gd name="connsiteY16" fmla="*/ 382772 h 829422"/>
                  <a:gd name="connsiteX17" fmla="*/ 851178 w 957503"/>
                  <a:gd name="connsiteY17" fmla="*/ 414670 h 829422"/>
                  <a:gd name="connsiteX18" fmla="*/ 883076 w 957503"/>
                  <a:gd name="connsiteY18" fmla="*/ 574159 h 829422"/>
                  <a:gd name="connsiteX19" fmla="*/ 893708 w 957503"/>
                  <a:gd name="connsiteY19" fmla="*/ 616689 h 829422"/>
                  <a:gd name="connsiteX20" fmla="*/ 925606 w 957503"/>
                  <a:gd name="connsiteY20" fmla="*/ 637954 h 829422"/>
                  <a:gd name="connsiteX21" fmla="*/ 957503 w 957503"/>
                  <a:gd name="connsiteY21" fmla="*/ 786810 h 829422"/>
                  <a:gd name="connsiteX22" fmla="*/ 946871 w 957503"/>
                  <a:gd name="connsiteY22" fmla="*/ 818707 h 829422"/>
                  <a:gd name="connsiteX23" fmla="*/ 840545 w 957503"/>
                  <a:gd name="connsiteY23" fmla="*/ 818707 h 829422"/>
                  <a:gd name="connsiteX24" fmla="*/ 776750 w 957503"/>
                  <a:gd name="connsiteY24" fmla="*/ 776177 h 829422"/>
                  <a:gd name="connsiteX25" fmla="*/ 691689 w 957503"/>
                  <a:gd name="connsiteY25" fmla="*/ 648586 h 829422"/>
                  <a:gd name="connsiteX26" fmla="*/ 659792 w 957503"/>
                  <a:gd name="connsiteY26" fmla="*/ 659219 h 829422"/>
                  <a:gd name="connsiteX27" fmla="*/ 585364 w 957503"/>
                  <a:gd name="connsiteY27" fmla="*/ 680484 h 829422"/>
                  <a:gd name="connsiteX28" fmla="*/ 532201 w 957503"/>
                  <a:gd name="connsiteY28" fmla="*/ 723014 h 829422"/>
                  <a:gd name="connsiteX29" fmla="*/ 500303 w 957503"/>
                  <a:gd name="connsiteY29" fmla="*/ 744279 h 829422"/>
                  <a:gd name="connsiteX30" fmla="*/ 436508 w 957503"/>
                  <a:gd name="connsiteY30" fmla="*/ 765545 h 829422"/>
                  <a:gd name="connsiteX31" fmla="*/ 404610 w 957503"/>
                  <a:gd name="connsiteY31" fmla="*/ 776177 h 829422"/>
                  <a:gd name="connsiteX32" fmla="*/ 362080 w 957503"/>
                  <a:gd name="connsiteY32" fmla="*/ 765545 h 829422"/>
                  <a:gd name="connsiteX33" fmla="*/ 213224 w 957503"/>
                  <a:gd name="connsiteY33" fmla="*/ 680484 h 829422"/>
                  <a:gd name="connsiteX34" fmla="*/ 181327 w 957503"/>
                  <a:gd name="connsiteY34" fmla="*/ 648586 h 829422"/>
                  <a:gd name="connsiteX35" fmla="*/ 128164 w 957503"/>
                  <a:gd name="connsiteY35" fmla="*/ 542261 h 829422"/>
                  <a:gd name="connsiteX36" fmla="*/ 96266 w 957503"/>
                  <a:gd name="connsiteY36" fmla="*/ 510363 h 829422"/>
                  <a:gd name="connsiteX37" fmla="*/ 32471 w 957503"/>
                  <a:gd name="connsiteY37" fmla="*/ 489098 h 829422"/>
                  <a:gd name="connsiteX38" fmla="*/ 573 w 957503"/>
                  <a:gd name="connsiteY38" fmla="*/ 457200 h 829422"/>
                  <a:gd name="connsiteX39" fmla="*/ 21838 w 957503"/>
                  <a:gd name="connsiteY39" fmla="*/ 329610 h 829422"/>
                  <a:gd name="connsiteX40" fmla="*/ 43103 w 957503"/>
                  <a:gd name="connsiteY40" fmla="*/ 297712 h 829422"/>
                  <a:gd name="connsiteX41" fmla="*/ 75001 w 957503"/>
                  <a:gd name="connsiteY41" fmla="*/ 287079 h 829422"/>
                  <a:gd name="connsiteX42" fmla="*/ 138796 w 957503"/>
                  <a:gd name="connsiteY42" fmla="*/ 255182 h 82942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</a:cxnLst>
                <a:rect l="l" t="t" r="r" b="b"/>
                <a:pathLst>
                  <a:path w="957503" h="829422">
                    <a:moveTo>
                      <a:pt x="138796" y="255182"/>
                    </a:moveTo>
                    <a:cubicBezTo>
                      <a:pt x="167150" y="232145"/>
                      <a:pt x="209680" y="184298"/>
                      <a:pt x="245122" y="148856"/>
                    </a:cubicBezTo>
                    <a:cubicBezTo>
                      <a:pt x="274596" y="119382"/>
                      <a:pt x="274202" y="97572"/>
                      <a:pt x="308917" y="74428"/>
                    </a:cubicBezTo>
                    <a:cubicBezTo>
                      <a:pt x="318242" y="68211"/>
                      <a:pt x="330182" y="67340"/>
                      <a:pt x="340815" y="63796"/>
                    </a:cubicBezTo>
                    <a:cubicBezTo>
                      <a:pt x="351448" y="56708"/>
                      <a:pt x="361618" y="48871"/>
                      <a:pt x="372713" y="42531"/>
                    </a:cubicBezTo>
                    <a:cubicBezTo>
                      <a:pt x="386475" y="34667"/>
                      <a:pt x="402055" y="30058"/>
                      <a:pt x="415243" y="21266"/>
                    </a:cubicBezTo>
                    <a:cubicBezTo>
                      <a:pt x="423584" y="15705"/>
                      <a:pt x="429420" y="7089"/>
                      <a:pt x="436508" y="0"/>
                    </a:cubicBezTo>
                    <a:cubicBezTo>
                      <a:pt x="500779" y="16068"/>
                      <a:pt x="465183" y="6014"/>
                      <a:pt x="542834" y="31898"/>
                    </a:cubicBezTo>
                    <a:lnTo>
                      <a:pt x="574731" y="42531"/>
                    </a:lnTo>
                    <a:cubicBezTo>
                      <a:pt x="585364" y="46075"/>
                      <a:pt x="596223" y="49001"/>
                      <a:pt x="606629" y="53163"/>
                    </a:cubicBezTo>
                    <a:cubicBezTo>
                      <a:pt x="634113" y="64156"/>
                      <a:pt x="696286" y="90233"/>
                      <a:pt x="723587" y="95693"/>
                    </a:cubicBezTo>
                    <a:cubicBezTo>
                      <a:pt x="801325" y="111241"/>
                      <a:pt x="758860" y="103770"/>
                      <a:pt x="851178" y="116959"/>
                    </a:cubicBezTo>
                    <a:cubicBezTo>
                      <a:pt x="934353" y="144684"/>
                      <a:pt x="908774" y="115643"/>
                      <a:pt x="925606" y="191386"/>
                    </a:cubicBezTo>
                    <a:cubicBezTo>
                      <a:pt x="928776" y="205651"/>
                      <a:pt x="932694" y="219740"/>
                      <a:pt x="936238" y="233917"/>
                    </a:cubicBezTo>
                    <a:cubicBezTo>
                      <a:pt x="932694" y="265815"/>
                      <a:pt x="937525" y="299812"/>
                      <a:pt x="925606" y="329610"/>
                    </a:cubicBezTo>
                    <a:cubicBezTo>
                      <a:pt x="921444" y="340016"/>
                      <a:pt x="902318" y="333067"/>
                      <a:pt x="893708" y="340242"/>
                    </a:cubicBezTo>
                    <a:cubicBezTo>
                      <a:pt x="880094" y="351586"/>
                      <a:pt x="872443" y="368595"/>
                      <a:pt x="861810" y="382772"/>
                    </a:cubicBezTo>
                    <a:cubicBezTo>
                      <a:pt x="858266" y="393405"/>
                      <a:pt x="851178" y="403462"/>
                      <a:pt x="851178" y="414670"/>
                    </a:cubicBezTo>
                    <a:cubicBezTo>
                      <a:pt x="851178" y="503947"/>
                      <a:pt x="860815" y="499957"/>
                      <a:pt x="883076" y="574159"/>
                    </a:cubicBezTo>
                    <a:cubicBezTo>
                      <a:pt x="887275" y="588156"/>
                      <a:pt x="885602" y="604530"/>
                      <a:pt x="893708" y="616689"/>
                    </a:cubicBezTo>
                    <a:cubicBezTo>
                      <a:pt x="900796" y="627322"/>
                      <a:pt x="914973" y="630866"/>
                      <a:pt x="925606" y="637954"/>
                    </a:cubicBezTo>
                    <a:cubicBezTo>
                      <a:pt x="949737" y="758608"/>
                      <a:pt x="938105" y="709214"/>
                      <a:pt x="957503" y="786810"/>
                    </a:cubicBezTo>
                    <a:cubicBezTo>
                      <a:pt x="953959" y="797442"/>
                      <a:pt x="955622" y="811706"/>
                      <a:pt x="946871" y="818707"/>
                    </a:cubicBezTo>
                    <a:cubicBezTo>
                      <a:pt x="919523" y="840585"/>
                      <a:pt x="865501" y="822866"/>
                      <a:pt x="840545" y="818707"/>
                    </a:cubicBezTo>
                    <a:cubicBezTo>
                      <a:pt x="819280" y="804530"/>
                      <a:pt x="784832" y="800423"/>
                      <a:pt x="776750" y="776177"/>
                    </a:cubicBezTo>
                    <a:cubicBezTo>
                      <a:pt x="738317" y="660878"/>
                      <a:pt x="773684" y="697783"/>
                      <a:pt x="691689" y="648586"/>
                    </a:cubicBezTo>
                    <a:cubicBezTo>
                      <a:pt x="681057" y="652130"/>
                      <a:pt x="670568" y="656140"/>
                      <a:pt x="659792" y="659219"/>
                    </a:cubicBezTo>
                    <a:cubicBezTo>
                      <a:pt x="566302" y="685932"/>
                      <a:pt x="661871" y="654983"/>
                      <a:pt x="585364" y="680484"/>
                    </a:cubicBezTo>
                    <a:cubicBezTo>
                      <a:pt x="549517" y="734256"/>
                      <a:pt x="583559" y="697336"/>
                      <a:pt x="532201" y="723014"/>
                    </a:cubicBezTo>
                    <a:cubicBezTo>
                      <a:pt x="520771" y="728729"/>
                      <a:pt x="511980" y="739089"/>
                      <a:pt x="500303" y="744279"/>
                    </a:cubicBezTo>
                    <a:cubicBezTo>
                      <a:pt x="479820" y="753383"/>
                      <a:pt x="457773" y="758457"/>
                      <a:pt x="436508" y="765545"/>
                    </a:cubicBezTo>
                    <a:lnTo>
                      <a:pt x="404610" y="776177"/>
                    </a:lnTo>
                    <a:cubicBezTo>
                      <a:pt x="390433" y="772633"/>
                      <a:pt x="375648" y="770972"/>
                      <a:pt x="362080" y="765545"/>
                    </a:cubicBezTo>
                    <a:cubicBezTo>
                      <a:pt x="310027" y="744724"/>
                      <a:pt x="259874" y="709640"/>
                      <a:pt x="213224" y="680484"/>
                    </a:cubicBezTo>
                    <a:cubicBezTo>
                      <a:pt x="200473" y="672515"/>
                      <a:pt x="191959" y="659219"/>
                      <a:pt x="181327" y="648586"/>
                    </a:cubicBezTo>
                    <a:cubicBezTo>
                      <a:pt x="165118" y="518917"/>
                      <a:pt x="198254" y="592325"/>
                      <a:pt x="128164" y="542261"/>
                    </a:cubicBezTo>
                    <a:cubicBezTo>
                      <a:pt x="115928" y="533521"/>
                      <a:pt x="109411" y="517666"/>
                      <a:pt x="96266" y="510363"/>
                    </a:cubicBezTo>
                    <a:cubicBezTo>
                      <a:pt x="76672" y="499477"/>
                      <a:pt x="32471" y="489098"/>
                      <a:pt x="32471" y="489098"/>
                    </a:cubicBezTo>
                    <a:cubicBezTo>
                      <a:pt x="21838" y="478465"/>
                      <a:pt x="3045" y="472032"/>
                      <a:pt x="573" y="457200"/>
                    </a:cubicBezTo>
                    <a:cubicBezTo>
                      <a:pt x="-2374" y="439517"/>
                      <a:pt x="6232" y="360823"/>
                      <a:pt x="21838" y="329610"/>
                    </a:cubicBezTo>
                    <a:cubicBezTo>
                      <a:pt x="27553" y="318180"/>
                      <a:pt x="33124" y="305695"/>
                      <a:pt x="43103" y="297712"/>
                    </a:cubicBezTo>
                    <a:cubicBezTo>
                      <a:pt x="51855" y="290710"/>
                      <a:pt x="64368" y="290623"/>
                      <a:pt x="75001" y="287079"/>
                    </a:cubicBezTo>
                    <a:cubicBezTo>
                      <a:pt x="100198" y="249284"/>
                      <a:pt x="110442" y="278219"/>
                      <a:pt x="138796" y="255182"/>
                    </a:cubicBezTo>
                    <a:close/>
                  </a:path>
                </a:pathLst>
              </a:custGeom>
              <a:pattFill prst="smConfetti">
                <a:fgClr>
                  <a:schemeClr val="bg1"/>
                </a:fgClr>
                <a:bgClr>
                  <a:srgbClr val="007434"/>
                </a:bgClr>
              </a:pattFill>
              <a:ln w="3175">
                <a:noFill/>
              </a:ln>
              <a:effectLst>
                <a:outerShdw sx="1000" sy="1000" algn="ctr">
                  <a:srgbClr val="00602B"/>
                </a:outerShdw>
              </a:effectLst>
              <a:scene3d>
                <a:camera prst="perspectiveFront" fov="2700000">
                  <a:rot lat="20376000" lon="1938000" rev="20112001"/>
                </a:camera>
                <a:lightRig rig="threePt" dir="t">
                  <a:rot lat="0" lon="0" rev="0"/>
                </a:lightRig>
              </a:scene3d>
              <a:sp3d prstMaterial="matte">
                <a:bevelT w="203200" h="50800" prst="coolSlant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63" name="Oval 47" descr="Pointillés"/>
              <p:cNvSpPr>
                <a:spLocks noChangeAspect="1" noChangeArrowheads="1"/>
              </p:cNvSpPr>
              <p:nvPr/>
            </p:nvSpPr>
            <p:spPr bwMode="auto">
              <a:xfrm rot="1947442">
                <a:off x="4374175" y="6247208"/>
                <a:ext cx="84535" cy="82770"/>
              </a:xfrm>
              <a:prstGeom prst="ellipse">
                <a:avLst/>
              </a:prstGeom>
              <a:pattFill prst="smConfetti">
                <a:fgClr>
                  <a:schemeClr val="bg1"/>
                </a:fgClr>
                <a:bgClr>
                  <a:srgbClr val="00602B"/>
                </a:bgClr>
              </a:pattFill>
              <a:ln w="19050">
                <a:noFill/>
                <a:round/>
                <a:headEnd/>
                <a:tailEnd/>
              </a:ln>
              <a:effectLst>
                <a:outerShdw blurRad="127000" dist="38100" dir="2700000" algn="ctr">
                  <a:srgbClr val="000000">
                    <a:alpha val="45000"/>
                  </a:srgbClr>
                </a:outerShdw>
              </a:effectLst>
              <a:scene3d>
                <a:camera prst="perspectiveFront" fov="2700000">
                  <a:rot lat="20376000" lon="1938000" rev="20112001"/>
                </a:camera>
                <a:lightRig rig="threePt" dir="t">
                  <a:rot lat="0" lon="0" rev="0"/>
                </a:lightRig>
              </a:scene3d>
              <a:sp3d>
                <a:bevelT w="203200" h="50800"/>
                <a:bevelB w="152400" h="50800" prst="softRound"/>
              </a:sp3d>
            </p:spPr>
            <p:txBody>
              <a:bodyPr wrap="none" anchor="ctr"/>
              <a:lstStyle/>
              <a:p>
                <a:pPr algn="ctr"/>
                <a:endParaRPr lang="fr-FR"/>
              </a:p>
            </p:txBody>
          </p:sp>
          <p:sp>
            <p:nvSpPr>
              <p:cNvPr id="65" name="Oval 49" descr="Pointillés"/>
              <p:cNvSpPr>
                <a:spLocks noChangeAspect="1" noChangeArrowheads="1"/>
              </p:cNvSpPr>
              <p:nvPr/>
            </p:nvSpPr>
            <p:spPr bwMode="auto">
              <a:xfrm rot="1947442">
                <a:off x="4408866" y="6834083"/>
                <a:ext cx="84535" cy="82770"/>
              </a:xfrm>
              <a:prstGeom prst="ellipse">
                <a:avLst/>
              </a:prstGeom>
              <a:pattFill prst="smConfetti">
                <a:fgClr>
                  <a:schemeClr val="bg1"/>
                </a:fgClr>
                <a:bgClr>
                  <a:srgbClr val="00602B"/>
                </a:bgClr>
              </a:pattFill>
              <a:ln w="19050">
                <a:noFill/>
                <a:round/>
                <a:headEnd/>
                <a:tailEnd/>
              </a:ln>
              <a:effectLst>
                <a:outerShdw blurRad="127000" dist="38100" dir="2700000" algn="ctr">
                  <a:srgbClr val="000000">
                    <a:alpha val="45000"/>
                  </a:srgbClr>
                </a:outerShdw>
              </a:effectLst>
              <a:scene3d>
                <a:camera prst="perspectiveFront" fov="2700000">
                  <a:rot lat="20376000" lon="1938000" rev="20112001"/>
                </a:camera>
                <a:lightRig rig="threePt" dir="t">
                  <a:rot lat="0" lon="0" rev="0"/>
                </a:lightRig>
              </a:scene3d>
              <a:sp3d>
                <a:bevelT w="203200" h="50800"/>
                <a:bevelB w="152400" h="50800" prst="softRound"/>
              </a:sp3d>
            </p:spPr>
            <p:txBody>
              <a:bodyPr wrap="none" anchor="ctr"/>
              <a:lstStyle/>
              <a:p>
                <a:pPr algn="ctr"/>
                <a:endParaRPr lang="fr-FR"/>
              </a:p>
            </p:txBody>
          </p:sp>
          <p:sp>
            <p:nvSpPr>
              <p:cNvPr id="66" name="Oval 49" descr="Pointillés"/>
              <p:cNvSpPr>
                <a:spLocks noChangeAspect="1" noChangeArrowheads="1"/>
              </p:cNvSpPr>
              <p:nvPr/>
            </p:nvSpPr>
            <p:spPr bwMode="auto">
              <a:xfrm rot="1947442">
                <a:off x="4431121" y="6500069"/>
                <a:ext cx="84479" cy="82235"/>
              </a:xfrm>
              <a:prstGeom prst="ellipse">
                <a:avLst/>
              </a:prstGeom>
              <a:pattFill prst="smConfetti">
                <a:fgClr>
                  <a:schemeClr val="bg1"/>
                </a:fgClr>
                <a:bgClr>
                  <a:srgbClr val="FF0000"/>
                </a:bgClr>
              </a:pattFill>
              <a:ln w="19050">
                <a:noFill/>
                <a:round/>
                <a:headEnd/>
                <a:tailEnd/>
              </a:ln>
              <a:effectLst>
                <a:outerShdw blurRad="127000" dist="38100" dir="2700000" algn="ctr">
                  <a:srgbClr val="000000">
                    <a:alpha val="45000"/>
                  </a:srgbClr>
                </a:outerShdw>
              </a:effectLst>
              <a:scene3d>
                <a:camera prst="perspectiveFront" fov="2700000">
                  <a:rot lat="20376000" lon="1938000" rev="20112001"/>
                </a:camera>
                <a:lightRig rig="threePt" dir="t">
                  <a:rot lat="0" lon="0" rev="0"/>
                </a:lightRig>
              </a:scene3d>
              <a:sp3d>
                <a:bevelT w="203200" h="50800"/>
                <a:bevelB w="152400" h="50800" prst="softRound"/>
              </a:sp3d>
            </p:spPr>
            <p:txBody>
              <a:bodyPr wrap="none" anchor="ctr"/>
              <a:lstStyle/>
              <a:p>
                <a:pPr algn="ctr"/>
                <a:endParaRPr lang="fr-FR"/>
              </a:p>
            </p:txBody>
          </p:sp>
          <p:sp>
            <p:nvSpPr>
              <p:cNvPr id="67" name="Oval 49" descr="Pointillés"/>
              <p:cNvSpPr>
                <a:spLocks noChangeAspect="1" noChangeArrowheads="1"/>
              </p:cNvSpPr>
              <p:nvPr/>
            </p:nvSpPr>
            <p:spPr bwMode="auto">
              <a:xfrm rot="1947442">
                <a:off x="4518298" y="6439183"/>
                <a:ext cx="84479" cy="82235"/>
              </a:xfrm>
              <a:prstGeom prst="ellipse">
                <a:avLst/>
              </a:prstGeom>
              <a:pattFill prst="smConfetti">
                <a:fgClr>
                  <a:schemeClr val="bg1"/>
                </a:fgClr>
                <a:bgClr>
                  <a:srgbClr val="FF0000"/>
                </a:bgClr>
              </a:pattFill>
              <a:ln w="19050">
                <a:noFill/>
                <a:round/>
                <a:headEnd/>
                <a:tailEnd/>
              </a:ln>
              <a:effectLst>
                <a:outerShdw blurRad="127000" dist="38100" dir="2700000" algn="ctr">
                  <a:srgbClr val="000000">
                    <a:alpha val="45000"/>
                  </a:srgbClr>
                </a:outerShdw>
              </a:effectLst>
              <a:scene3d>
                <a:camera prst="perspectiveFront" fov="2700000">
                  <a:rot lat="20376000" lon="1938000" rev="20112001"/>
                </a:camera>
                <a:lightRig rig="threePt" dir="t">
                  <a:rot lat="0" lon="0" rev="0"/>
                </a:lightRig>
              </a:scene3d>
              <a:sp3d>
                <a:bevelT w="203200" h="50800"/>
                <a:bevelB w="152400" h="50800" prst="softRound"/>
              </a:sp3d>
            </p:spPr>
            <p:txBody>
              <a:bodyPr wrap="none" anchor="ctr"/>
              <a:lstStyle/>
              <a:p>
                <a:pPr algn="ctr"/>
                <a:endParaRPr lang="fr-FR"/>
              </a:p>
            </p:txBody>
          </p:sp>
          <p:sp>
            <p:nvSpPr>
              <p:cNvPr id="68" name="Oval 49" descr="Pointillés"/>
              <p:cNvSpPr>
                <a:spLocks noChangeAspect="1" noChangeArrowheads="1"/>
              </p:cNvSpPr>
              <p:nvPr/>
            </p:nvSpPr>
            <p:spPr bwMode="auto">
              <a:xfrm rot="1947442">
                <a:off x="4548199" y="6523196"/>
                <a:ext cx="84479" cy="82235"/>
              </a:xfrm>
              <a:prstGeom prst="ellipse">
                <a:avLst/>
              </a:prstGeom>
              <a:pattFill prst="smConfetti">
                <a:fgClr>
                  <a:schemeClr val="bg1"/>
                </a:fgClr>
                <a:bgClr>
                  <a:srgbClr val="FF0000"/>
                </a:bgClr>
              </a:pattFill>
              <a:ln w="19050">
                <a:noFill/>
                <a:round/>
                <a:headEnd/>
                <a:tailEnd/>
              </a:ln>
              <a:effectLst>
                <a:outerShdw blurRad="127000" dist="38100" dir="2700000" algn="ctr">
                  <a:srgbClr val="000000">
                    <a:alpha val="45000"/>
                  </a:srgbClr>
                </a:outerShdw>
              </a:effectLst>
              <a:scene3d>
                <a:camera prst="perspectiveFront" fov="2700000">
                  <a:rot lat="20376000" lon="1938000" rev="20112001"/>
                </a:camera>
                <a:lightRig rig="threePt" dir="t">
                  <a:rot lat="0" lon="0" rev="0"/>
                </a:lightRig>
              </a:scene3d>
              <a:sp3d>
                <a:bevelT w="203200" h="50800"/>
                <a:bevelB w="152400" h="50800" prst="softRound"/>
              </a:sp3d>
            </p:spPr>
            <p:txBody>
              <a:bodyPr wrap="none" anchor="ctr"/>
              <a:lstStyle/>
              <a:p>
                <a:pPr algn="ctr"/>
                <a:endParaRPr lang="fr-FR"/>
              </a:p>
            </p:txBody>
          </p:sp>
        </p:grpSp>
        <p:sp>
          <p:nvSpPr>
            <p:cNvPr id="69" name="Oval 49" descr="Pointillés"/>
            <p:cNvSpPr>
              <a:spLocks noChangeAspect="1" noChangeArrowheads="1"/>
            </p:cNvSpPr>
            <p:nvPr/>
          </p:nvSpPr>
          <p:spPr bwMode="auto">
            <a:xfrm rot="1947442">
              <a:off x="5731862" y="1652245"/>
              <a:ext cx="61448" cy="62431"/>
            </a:xfrm>
            <a:prstGeom prst="ellipse">
              <a:avLst/>
            </a:prstGeom>
            <a:pattFill prst="smConfetti">
              <a:fgClr>
                <a:schemeClr val="bg1"/>
              </a:fgClr>
              <a:bgClr>
                <a:srgbClr val="00602B"/>
              </a:bgClr>
            </a:pattFill>
            <a:ln w="19050">
              <a:noFill/>
              <a:round/>
              <a:headEnd/>
              <a:tailEnd/>
            </a:ln>
            <a:effectLst>
              <a:outerShdw blurRad="127000" dist="38100" dir="2700000" algn="ctr">
                <a:srgbClr val="000000">
                  <a:alpha val="45000"/>
                </a:srgbClr>
              </a:outerShdw>
            </a:effectLst>
            <a:scene3d>
              <a:camera prst="perspectiveFront" fov="2700000">
                <a:rot lat="20376000" lon="1938000" rev="20112001"/>
              </a:camera>
              <a:lightRig rig="threePt" dir="t">
                <a:rot lat="0" lon="0" rev="0"/>
              </a:lightRig>
            </a:scene3d>
            <a:sp3d>
              <a:bevelT w="203200" h="50800"/>
              <a:bevelB w="152400" h="50800" prst="softRound"/>
            </a:sp3d>
          </p:spPr>
          <p:txBody>
            <a:bodyPr wrap="none" anchor="ctr"/>
            <a:lstStyle/>
            <a:p>
              <a:pPr algn="ctr"/>
              <a:endParaRPr lang="fr-FR"/>
            </a:p>
          </p:txBody>
        </p:sp>
        <p:sp>
          <p:nvSpPr>
            <p:cNvPr id="72" name="Text Box 10"/>
            <p:cNvSpPr txBox="1">
              <a:spLocks noChangeArrowheads="1"/>
            </p:cNvSpPr>
            <p:nvPr/>
          </p:nvSpPr>
          <p:spPr bwMode="auto">
            <a:xfrm>
              <a:off x="1052736" y="3861623"/>
              <a:ext cx="1080120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fr-FR" sz="1000" dirty="0" err="1">
                  <a:latin typeface="Times New Roman" pitchFamily="18" charset="0"/>
                  <a:cs typeface="Times New Roman" pitchFamily="18" charset="0"/>
                </a:rPr>
                <a:t>DsRed</a:t>
              </a:r>
              <a:r>
                <a:rPr lang="fr-FR" sz="1000" dirty="0">
                  <a:latin typeface="Times New Roman" pitchFamily="18" charset="0"/>
                  <a:cs typeface="Times New Roman" pitchFamily="18" charset="0"/>
                </a:rPr>
                <a:t> cell clones</a:t>
              </a:r>
            </a:p>
          </p:txBody>
        </p:sp>
        <p:sp>
          <p:nvSpPr>
            <p:cNvPr id="73" name="Text Box 10"/>
            <p:cNvSpPr txBox="1">
              <a:spLocks noChangeArrowheads="1"/>
            </p:cNvSpPr>
            <p:nvPr/>
          </p:nvSpPr>
          <p:spPr bwMode="auto">
            <a:xfrm>
              <a:off x="2178944" y="3864241"/>
              <a:ext cx="1080120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fr-FR" sz="1000" dirty="0">
                  <a:latin typeface="Times New Roman" pitchFamily="18" charset="0"/>
                  <a:cs typeface="Times New Roman" pitchFamily="18" charset="0"/>
                </a:rPr>
                <a:t>GFP cell </a:t>
              </a:r>
            </a:p>
            <a:p>
              <a:pPr algn="ctr"/>
              <a:r>
                <a:rPr lang="fr-FR" sz="1000" dirty="0">
                  <a:latin typeface="Times New Roman" pitchFamily="18" charset="0"/>
                  <a:cs typeface="Times New Roman" pitchFamily="18" charset="0"/>
                </a:rPr>
                <a:t>clones</a:t>
              </a:r>
            </a:p>
          </p:txBody>
        </p:sp>
      </p:grpSp>
      <p:sp>
        <p:nvSpPr>
          <p:cNvPr id="8" name="ZoneTexte 7"/>
          <p:cNvSpPr txBox="1"/>
          <p:nvPr/>
        </p:nvSpPr>
        <p:spPr>
          <a:xfrm>
            <a:off x="0" y="4376936"/>
            <a:ext cx="6858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chematic representation of heterogeneous adherent cell co-cultures using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sRe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GFP-expressing cells.</a:t>
            </a:r>
            <a:endParaRPr lang="en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79208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ZoneTexte 7"/>
          <p:cNvSpPr txBox="1"/>
          <p:nvPr/>
        </p:nvSpPr>
        <p:spPr>
          <a:xfrm>
            <a:off x="0" y="7905328"/>
            <a:ext cx="685800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Cell viability of A549 and A549/EpoB40 cells measured by MTT assay after a 72h exposition to increasing concentrations of chemotherapeutic agents (cisplatin or patupilone). Results were expressed as a percentage of viability in non-treated cells. (b) Cell viability of A549 and A549/VP16 cells (left panel) and HT29 and HT29/Rox1 cells (right panel) measured by MTT assay after a 72h exposition to increasing concentrations of etoposide or oxaliplatin. Results were expressed as a percentage of viability in non-treated cells. (c) Cell proliferation of A549 and A549/VP16 (left panel) and HT29 and HT29/Rox1 (right panel) by recording fluorescent signals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sRe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GFP) over time. Data were expressed as a percentage of cell proliferation from day 0. (d) Doubling time of A549 and A549/EpoB40 cells assessed by real time impedance-based method. (e) Standard curve showing the conversion of fluorescent signal into a number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sRe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expressing A549/EpoB40 cells in 3D co-culture models. </a:t>
            </a:r>
            <a:endParaRPr lang="en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C854FFE1-69E3-984D-A2A7-15C800FD2C9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7392" y="5601072"/>
            <a:ext cx="2331720" cy="185928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01EF960-DD5D-5441-925E-0A0A608B7B8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39" y="3584848"/>
            <a:ext cx="2619692" cy="19800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F927FCC2-C9C3-0846-843C-9BB41497B12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8046" y="3584848"/>
            <a:ext cx="2551154" cy="198000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C17D4811-43CF-A640-A463-BF5219BAB07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332" y="-131391"/>
            <a:ext cx="2232660" cy="1744980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60D6B159-60EA-064B-AA81-7D0380E0B5E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73298" y="1721206"/>
            <a:ext cx="2232660" cy="1744980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B484BA18-2502-644F-90F2-3020543DBCC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73298" y="-131391"/>
            <a:ext cx="2232660" cy="1744980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431C7546-F853-5E48-8FC6-10BF1041C80E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332" y="1721206"/>
            <a:ext cx="2232660" cy="1744980"/>
          </a:xfrm>
          <a:prstGeom prst="rect">
            <a:avLst/>
          </a:prstGeom>
        </p:spPr>
      </p:pic>
      <p:sp>
        <p:nvSpPr>
          <p:cNvPr id="16" name="ZoneTexte 45">
            <a:extLst>
              <a:ext uri="{FF2B5EF4-FFF2-40B4-BE49-F238E27FC236}">
                <a16:creationId xmlns:a16="http://schemas.microsoft.com/office/drawing/2014/main" id="{430249FE-2F60-E248-9EAD-67A40B56D7FC}"/>
              </a:ext>
            </a:extLst>
          </p:cNvPr>
          <p:cNvSpPr txBox="1"/>
          <p:nvPr/>
        </p:nvSpPr>
        <p:spPr>
          <a:xfrm>
            <a:off x="2352732" y="5431865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</a:p>
        </p:txBody>
      </p:sp>
      <p:sp>
        <p:nvSpPr>
          <p:cNvPr id="17" name="ZoneTexte 46">
            <a:extLst>
              <a:ext uri="{FF2B5EF4-FFF2-40B4-BE49-F238E27FC236}">
                <a16:creationId xmlns:a16="http://schemas.microsoft.com/office/drawing/2014/main" id="{AF4713ED-53C4-8A49-AEB4-80C86043DAC7}"/>
              </a:ext>
            </a:extLst>
          </p:cNvPr>
          <p:cNvSpPr txBox="1"/>
          <p:nvPr/>
        </p:nvSpPr>
        <p:spPr>
          <a:xfrm>
            <a:off x="712925" y="7308679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</a:p>
        </p:txBody>
      </p:sp>
      <p:sp>
        <p:nvSpPr>
          <p:cNvPr id="18" name="ZoneTexte 45">
            <a:extLst>
              <a:ext uri="{FF2B5EF4-FFF2-40B4-BE49-F238E27FC236}">
                <a16:creationId xmlns:a16="http://schemas.microsoft.com/office/drawing/2014/main" id="{612E42B5-637C-7E4F-A879-27EC6027D526}"/>
              </a:ext>
            </a:extLst>
          </p:cNvPr>
          <p:cNvSpPr txBox="1"/>
          <p:nvPr/>
        </p:nvSpPr>
        <p:spPr>
          <a:xfrm>
            <a:off x="2344718" y="1523201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20" name="ZoneTexte 46">
            <a:extLst>
              <a:ext uri="{FF2B5EF4-FFF2-40B4-BE49-F238E27FC236}">
                <a16:creationId xmlns:a16="http://schemas.microsoft.com/office/drawing/2014/main" id="{0A70A5D6-1AE2-754A-9549-6B363BE03FB7}"/>
              </a:ext>
            </a:extLst>
          </p:cNvPr>
          <p:cNvSpPr txBox="1"/>
          <p:nvPr/>
        </p:nvSpPr>
        <p:spPr>
          <a:xfrm>
            <a:off x="2336702" y="3451865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23" name="ZoneTexte 46">
            <a:extLst>
              <a:ext uri="{FF2B5EF4-FFF2-40B4-BE49-F238E27FC236}">
                <a16:creationId xmlns:a16="http://schemas.microsoft.com/office/drawing/2014/main" id="{EE8546B6-660B-5C4F-BA0E-490506A1904A}"/>
              </a:ext>
            </a:extLst>
          </p:cNvPr>
          <p:cNvSpPr txBox="1"/>
          <p:nvPr/>
        </p:nvSpPr>
        <p:spPr>
          <a:xfrm>
            <a:off x="2928796" y="7543393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7F81F0C5-CE3F-3D4D-978E-C3BCF788FE61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620" y="5607144"/>
            <a:ext cx="1120140" cy="17221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331778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1">
            <a:extLst>
              <a:ext uri="{FF2B5EF4-FFF2-40B4-BE49-F238E27FC236}">
                <a16:creationId xmlns:a16="http://schemas.microsoft.com/office/drawing/2014/main" id="{536AFEA2-31B4-8F42-8485-CC6AAA93312D}"/>
              </a:ext>
            </a:extLst>
          </p:cNvPr>
          <p:cNvSpPr txBox="1"/>
          <p:nvPr/>
        </p:nvSpPr>
        <p:spPr>
          <a:xfrm>
            <a:off x="0" y="8481392"/>
            <a:ext cx="6858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mathematical model is described by a set of three equations where variables of the growth model and parameters values are detailed.  </a:t>
            </a:r>
            <a:endParaRPr lang="en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D14AED6-01F2-6E4F-879D-BB783330A3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6956" y="560512"/>
            <a:ext cx="5564088" cy="76327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31930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1">
            <a:extLst>
              <a:ext uri="{FF2B5EF4-FFF2-40B4-BE49-F238E27FC236}">
                <a16:creationId xmlns:a16="http://schemas.microsoft.com/office/drawing/2014/main" id="{8E068BE7-9002-A343-9648-0CF7D7606786}"/>
              </a:ext>
            </a:extLst>
          </p:cNvPr>
          <p:cNvSpPr txBox="1"/>
          <p:nvPr/>
        </p:nvSpPr>
        <p:spPr>
          <a:xfrm>
            <a:off x="0" y="8985448"/>
            <a:ext cx="685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thematical analysis of the model.  </a:t>
            </a:r>
            <a:endParaRPr lang="en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F81309CE-15FB-7A47-B3B0-0D83B60462D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2252" y="6393160"/>
            <a:ext cx="4173496" cy="2555577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419C7E6F-98F2-DF41-9503-6583A4286A3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42253" y="854498"/>
            <a:ext cx="4141970" cy="57261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509574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ZoneTexte 60"/>
          <p:cNvSpPr txBox="1"/>
          <p:nvPr/>
        </p:nvSpPr>
        <p:spPr>
          <a:xfrm>
            <a:off x="0" y="2641193"/>
            <a:ext cx="6858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Cell viability of A549 and A549/EpoB40 cells measured by MTT assay after a 72h exposition to increasing concentrations of FXII. Results were expressed as a percentage of viability in non-treated cells. (b) A549/EpoB40 cell growth was studied by real time impedance-based method. A549/EpoB40 cells were treated daily with cell-free supernatants from A549 cultures and from A549/EpoB40 cultures with or without 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itchFamily="2" charset="2"/>
              </a:rPr>
              <a:t>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of FXII. Measurements were performed every 15 minutes.</a:t>
            </a:r>
            <a:endParaRPr lang="en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8335D40-02F1-4F40-A75F-57C949DB3A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68960" y="219421"/>
            <a:ext cx="3464560" cy="1910080"/>
          </a:xfrm>
          <a:prstGeom prst="rect">
            <a:avLst/>
          </a:prstGeom>
        </p:spPr>
      </p:pic>
      <p:sp>
        <p:nvSpPr>
          <p:cNvPr id="10" name="ZoneTexte 55">
            <a:extLst>
              <a:ext uri="{FF2B5EF4-FFF2-40B4-BE49-F238E27FC236}">
                <a16:creationId xmlns:a16="http://schemas.microsoft.com/office/drawing/2014/main" id="{28716BB0-6EFB-9B44-A6C9-75E99063757E}"/>
              </a:ext>
            </a:extLst>
          </p:cNvPr>
          <p:cNvSpPr txBox="1"/>
          <p:nvPr/>
        </p:nvSpPr>
        <p:spPr>
          <a:xfrm>
            <a:off x="4877309" y="2155723"/>
            <a:ext cx="279883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fr-FR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(b)</a:t>
            </a:r>
            <a:endParaRPr kumimoji="0" lang="fr-FR" sz="120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Times New Roman" panose="02020603050405020304" pitchFamily="18" charset="0"/>
              <a:cs typeface="Times New Roman" panose="02020603050405020304" pitchFamily="18" charset="0"/>
              <a:sym typeface="Calibri"/>
            </a:endParaRPr>
          </a:p>
        </p:txBody>
      </p:sp>
      <p:sp>
        <p:nvSpPr>
          <p:cNvPr id="11" name="ZoneTexte 58">
            <a:extLst>
              <a:ext uri="{FF2B5EF4-FFF2-40B4-BE49-F238E27FC236}">
                <a16:creationId xmlns:a16="http://schemas.microsoft.com/office/drawing/2014/main" id="{03C4C553-1EE1-C445-A63B-82B5CA34065C}"/>
              </a:ext>
            </a:extLst>
          </p:cNvPr>
          <p:cNvSpPr txBox="1"/>
          <p:nvPr/>
        </p:nvSpPr>
        <p:spPr>
          <a:xfrm>
            <a:off x="1365930" y="2155723"/>
            <a:ext cx="27186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fr-FR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(a)</a:t>
            </a:r>
            <a:endParaRPr kumimoji="0" lang="fr-FR" sz="120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Times New Roman" panose="02020603050405020304" pitchFamily="18" charset="0"/>
              <a:cs typeface="Times New Roman" panose="02020603050405020304" pitchFamily="18" charset="0"/>
              <a:sym typeface="Calibri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1797F45-CE51-D546-B2D5-7F99BED2470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098" y="-4517"/>
            <a:ext cx="2604770" cy="20358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2188215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09</TotalTime>
  <Words>381</Words>
  <Application>Microsoft Macintosh PowerPoint</Application>
  <PresentationFormat>A4 Paper (210x297 mm)</PresentationFormat>
  <Paragraphs>26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Times New Roman</vt:lpstr>
      <vt:lpstr>Thème Offic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CISCA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non carre</dc:creator>
  <cp:lastModifiedBy>Microsoft Office User</cp:lastModifiedBy>
  <cp:revision>238</cp:revision>
  <dcterms:created xsi:type="dcterms:W3CDTF">2014-03-07T14:58:31Z</dcterms:created>
  <dcterms:modified xsi:type="dcterms:W3CDTF">2021-04-28T10:37:51Z</dcterms:modified>
</cp:coreProperties>
</file>